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wn Vahabzadeh, PharmD (MTM)" initials="SVP(" lastIdx="10" clrIdx="0">
    <p:extLst>
      <p:ext uri="{19B8F6BF-5375-455C-9EA6-DF929625EA0E}">
        <p15:presenceInfo xmlns:p15="http://schemas.microsoft.com/office/powerpoint/2012/main" userId="S-1-5-21-2754625900-2601979746-2412578218-11731" providerId="AD"/>
      </p:ext>
    </p:extLst>
  </p:cmAuthor>
  <p:cmAuthor id="2" name="Shawn Vahabzadeh, PharmD (MTM)" initials="SVP( [2]" lastIdx="16" clrIdx="1">
    <p:extLst>
      <p:ext uri="{19B8F6BF-5375-455C-9EA6-DF929625EA0E}">
        <p15:presenceInfo xmlns:p15="http://schemas.microsoft.com/office/powerpoint/2012/main" userId="S::Shawn.Vahabzadeh@meditechmedia.com::8407814f-7d61-4076-90b4-a45247fb421d" providerId="AD"/>
      </p:ext>
    </p:extLst>
  </p:cmAuthor>
  <p:cmAuthor id="3" name="Mihaela Marina, PhD (MTM)" initials="MMP(" lastIdx="2" clrIdx="2">
    <p:extLst>
      <p:ext uri="{19B8F6BF-5375-455C-9EA6-DF929625EA0E}">
        <p15:presenceInfo xmlns:p15="http://schemas.microsoft.com/office/powerpoint/2012/main" userId="S::Mihaela.Marina@meditechmedia.com::7d92716a-fcf1-4ee5-8b29-5c80102b01ec" providerId="AD"/>
      </p:ext>
    </p:extLst>
  </p:cmAuthor>
  <p:cmAuthor id="4" name="Kerry Garza, PhD (MTM)" initials="KGP(" lastIdx="1" clrIdx="3">
    <p:extLst>
      <p:ext uri="{19B8F6BF-5375-455C-9EA6-DF929625EA0E}">
        <p15:presenceInfo xmlns:p15="http://schemas.microsoft.com/office/powerpoint/2012/main" userId="S::Kerry.Garza@meditechmedia.com::f4e76a70-b598-4fb8-9249-00fb37dcbcf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1" d="100"/>
          <a:sy n="81" d="100"/>
        </p:scale>
        <p:origin x="114" y="1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CF7B04-DB20-4F80-BC0B-BE73FC1FF19B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4D31DB-BDA9-4411-A6B4-DA8E30374E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4022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D0F2F8-8EDC-49FC-8241-ED911DEA46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F274BE0-9E6C-4E16-8737-26911C16BF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779BA7-1D7E-4FC7-9802-232CC18B6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76F9E-C824-4E91-9540-C0F604E9A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FB0A0-82A8-44F2-91B1-0E3DC0077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522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2BC04-51C1-4C7A-B0C9-3B29161D3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3DB4C4-BD54-4A84-87C9-74E7EBB719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FB588C-B6BE-4CD1-AC13-BD5068F315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7306C-A1A6-4443-9800-FDBF53C31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52C82-C0C4-439B-AB00-730BE6034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445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F834FF-4EBD-4FAB-955A-6295CED360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A6C2CF-15DE-4302-9BCF-4D12EF2DB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13713-FEBC-45BA-9BE1-F33222BD3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D4430-032A-4ED7-9DE4-22ED13BFE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B55C2B-6700-4193-99E2-28DC04B50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215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0AD3A-FEED-4E19-9E35-132E1EA023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7342AF-3B19-4EC3-91A7-DDA84EDCAD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448CE-73F9-47D3-96F8-81C8D79A7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1B96F-E8A3-4B54-A0A4-60F4D0861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56346-E2EC-4C8B-992F-F45993CFE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A1035-750D-48CC-A966-C02C2C37D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356EE-F460-4CE2-8150-55B8019B8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84991-69AD-4BEA-97E7-2398040BE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1FF1DE-E32F-42EE-A098-EB728B73E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A45F1-8F16-45DB-8C7F-E580259B4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47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6FDAA-BD01-4A3C-9937-8B8EC440A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7BB6C7-C538-4C9F-B38E-73EF570105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9D1F4F-0916-43DB-95A2-6E82D86170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B4D148-4AB4-4FB1-BFEC-FC894CFED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9B4010-C9CD-486C-8C1C-85A86D4B0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F6E868-F1F2-43F1-AE00-4931C25C7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06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4B9BD-3A56-4568-8D94-A56775B17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58F85-C64D-4B50-B2A4-028186408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4E9A08-04DB-4AB6-8E11-68684487D8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1DA1D6-6A0D-4565-AF93-2CD893EAF3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751BBA-6380-4631-B09D-E04DF7CC48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A0F4E2-3289-4180-9729-114937A9C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077B10-67B4-4B35-9E45-9DE9DF216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3F01D2-0FDD-45A6-943D-98D039DC3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744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DB2D0-EC6E-4C14-B176-4B79FDA690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DD6F7E-A9ED-4557-BB7E-E81DACB15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281D85-1568-4F8B-A7AC-05387FE9E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922F02-18CF-4C31-A96D-69F74FC2B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47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46232E-5ED5-4129-90C9-6C2E2F504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C44D1F-734B-41C7-8A28-C4F111053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2524A9-F1D0-4A52-84F4-882F6B9CD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074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6B691-ACA6-4739-894C-0AACBA40D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E00E4-CB86-441A-B7E2-9651EDBF95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EC724B-ADE1-456D-8641-6D2F07413B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66277A-028B-4F3B-B640-B79856C21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AE577F-B0AC-4EC1-8B5A-AB653D621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3FDB6B-D020-457F-93E3-3A47CACDF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10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13530-847B-4EA5-B525-826E900633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670428-8077-484F-AF6A-A6DAD4AD55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0FAE95-3E50-4529-9F33-A3F5F7FB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2EA920-0AE0-4FFF-B5BA-0F3C2FC6C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B7295-58FE-4167-82AD-5BDF1FA6B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100CAF-FB30-42E6-9C8F-629A3D698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471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90FB55-2BED-4098-8A24-61DFF2047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E1CC5D-E3B0-4B04-A475-B16B546E74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64E550-4BE0-4B41-A1B1-3DF5DFCAA2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FBE04-859A-4412-9226-67F87E12C7DA}" type="datetimeFigureOut">
              <a:rPr lang="en-US" smtClean="0"/>
              <a:t>5/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4B1B3-A1DD-4859-92C9-5673F9F03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66C937-234E-4EF6-AC65-93D4C0B321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80B17-3A6F-4017-8EA7-0C95F63CB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9" name="Group 168">
            <a:extLst>
              <a:ext uri="{FF2B5EF4-FFF2-40B4-BE49-F238E27FC236}">
                <a16:creationId xmlns:a16="http://schemas.microsoft.com/office/drawing/2014/main" id="{84F7BCBD-A0CE-429B-B4EC-3A9378AFAEC1}"/>
              </a:ext>
            </a:extLst>
          </p:cNvPr>
          <p:cNvGrpSpPr/>
          <p:nvPr/>
        </p:nvGrpSpPr>
        <p:grpSpPr>
          <a:xfrm>
            <a:off x="3624581" y="1463675"/>
            <a:ext cx="5608638" cy="3116263"/>
            <a:chOff x="3708401" y="1463675"/>
            <a:chExt cx="5608638" cy="3116263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529FBFC8-C02D-41C3-B3CF-FC2D67E7AD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762376" y="2990850"/>
              <a:ext cx="5554663" cy="0"/>
            </a:xfrm>
            <a:prstGeom prst="line">
              <a:avLst/>
            </a:prstGeom>
            <a:noFill/>
            <a:ln w="14351" cap="flat">
              <a:solidFill>
                <a:schemeClr val="tx1"/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2C0F7D91-45F6-4C5A-A066-ED64E7D8E967}"/>
                </a:ext>
              </a:extLst>
            </p:cNvPr>
            <p:cNvGrpSpPr/>
            <p:nvPr/>
          </p:nvGrpSpPr>
          <p:grpSpPr>
            <a:xfrm>
              <a:off x="3708401" y="1463675"/>
              <a:ext cx="5608638" cy="3116263"/>
              <a:chOff x="3708401" y="1463675"/>
              <a:chExt cx="5608638" cy="3116263"/>
            </a:xfrm>
          </p:grpSpPr>
          <p:sp>
            <p:nvSpPr>
              <p:cNvPr id="9" name="Line 6">
                <a:extLst>
                  <a:ext uri="{FF2B5EF4-FFF2-40B4-BE49-F238E27FC236}">
                    <a16:creationId xmlns:a16="http://schemas.microsoft.com/office/drawing/2014/main" id="{9B5B4AD3-A88D-4AEF-A544-7509CEB8F5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4462463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Line 7">
                <a:extLst>
                  <a:ext uri="{FF2B5EF4-FFF2-40B4-BE49-F238E27FC236}">
                    <a16:creationId xmlns:a16="http://schemas.microsoft.com/office/drawing/2014/main" id="{1689AA02-B2CE-4613-B2DE-E705D08F3B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3876675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Line 8">
                <a:extLst>
                  <a:ext uri="{FF2B5EF4-FFF2-40B4-BE49-F238E27FC236}">
                    <a16:creationId xmlns:a16="http://schemas.microsoft.com/office/drawing/2014/main" id="{6DFC0005-223B-42A7-BF72-742D78D55C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3290888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E2B3D6C3-70F3-4D43-8CD4-A417A3F886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2698750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28EF00D6-6D5C-47CC-A251-3E81156EBB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2109788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Line 11">
                <a:extLst>
                  <a:ext uri="{FF2B5EF4-FFF2-40B4-BE49-F238E27FC236}">
                    <a16:creationId xmlns:a16="http://schemas.microsoft.com/office/drawing/2014/main" id="{870AB7A0-CCAF-4926-AC98-1F68CE3DF2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08401" y="1524000"/>
                <a:ext cx="53975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Line 18">
                <a:extLst>
                  <a:ext uri="{FF2B5EF4-FFF2-40B4-BE49-F238E27FC236}">
                    <a16:creationId xmlns:a16="http://schemas.microsoft.com/office/drawing/2014/main" id="{4924C610-D9CA-4AED-BB91-5E566C1ECA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3026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Line 19">
                <a:extLst>
                  <a:ext uri="{FF2B5EF4-FFF2-40B4-BE49-F238E27FC236}">
                    <a16:creationId xmlns:a16="http://schemas.microsoft.com/office/drawing/2014/main" id="{386572A1-FDBC-4D08-940E-F8E271122F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4026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Line 20">
                <a:extLst>
                  <a:ext uri="{FF2B5EF4-FFF2-40B4-BE49-F238E27FC236}">
                    <a16:creationId xmlns:a16="http://schemas.microsoft.com/office/drawing/2014/main" id="{D529F3AE-E36D-4756-B909-D9358A01C2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434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Line 21">
                <a:extLst>
                  <a:ext uri="{FF2B5EF4-FFF2-40B4-BE49-F238E27FC236}">
                    <a16:creationId xmlns:a16="http://schemas.microsoft.com/office/drawing/2014/main" id="{B160E7F4-22E2-4860-8F31-8E92CB1188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2126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Line 22">
                <a:extLst>
                  <a:ext uri="{FF2B5EF4-FFF2-40B4-BE49-F238E27FC236}">
                    <a16:creationId xmlns:a16="http://schemas.microsoft.com/office/drawing/2014/main" id="{EFC37E05-A1F2-4D60-9024-563A0F0E8F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0226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Line 23">
                <a:extLst>
                  <a:ext uri="{FF2B5EF4-FFF2-40B4-BE49-F238E27FC236}">
                    <a16:creationId xmlns:a16="http://schemas.microsoft.com/office/drawing/2014/main" id="{F410C4D6-627A-4679-9809-E1642F2EAD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81676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Line 24">
                <a:extLst>
                  <a:ext uri="{FF2B5EF4-FFF2-40B4-BE49-F238E27FC236}">
                    <a16:creationId xmlns:a16="http://schemas.microsoft.com/office/drawing/2014/main" id="{45C78561-3340-4D18-BD03-32FA0975CC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59501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Line 25">
                <a:extLst>
                  <a:ext uri="{FF2B5EF4-FFF2-40B4-BE49-F238E27FC236}">
                    <a16:creationId xmlns:a16="http://schemas.microsoft.com/office/drawing/2014/main" id="{D36B9907-6509-4746-BC14-0A9F6C57B3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0501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Line 26">
                <a:extLst>
                  <a:ext uri="{FF2B5EF4-FFF2-40B4-BE49-F238E27FC236}">
                    <a16:creationId xmlns:a16="http://schemas.microsoft.com/office/drawing/2014/main" id="{2AE0A45B-5B09-4B81-939E-A7752BD870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19913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Line 27">
                <a:extLst>
                  <a:ext uri="{FF2B5EF4-FFF2-40B4-BE49-F238E27FC236}">
                    <a16:creationId xmlns:a16="http://schemas.microsoft.com/office/drawing/2014/main" id="{0A7CF46D-A9D5-4A6A-BB75-F24BEEFF16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977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1" name="Line 28">
                <a:extLst>
                  <a:ext uri="{FF2B5EF4-FFF2-40B4-BE49-F238E27FC236}">
                    <a16:creationId xmlns:a16="http://schemas.microsoft.com/office/drawing/2014/main" id="{B3D55333-B3FB-48A5-A6F9-D183FC56C8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7873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Line 29">
                <a:extLst>
                  <a:ext uri="{FF2B5EF4-FFF2-40B4-BE49-F238E27FC236}">
                    <a16:creationId xmlns:a16="http://schemas.microsoft.com/office/drawing/2014/main" id="{F45A2445-439B-474A-B312-42D533FCDF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58151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Line 30">
                <a:extLst>
                  <a:ext uri="{FF2B5EF4-FFF2-40B4-BE49-F238E27FC236}">
                    <a16:creationId xmlns:a16="http://schemas.microsoft.com/office/drawing/2014/main" id="{C7857070-D52A-4C6E-8443-92E4E382B1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35976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" name="Line 31">
                <a:extLst>
                  <a:ext uri="{FF2B5EF4-FFF2-40B4-BE49-F238E27FC236}">
                    <a16:creationId xmlns:a16="http://schemas.microsoft.com/office/drawing/2014/main" id="{9307E47C-73DC-4022-A53D-FF08B0F9F4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13801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Line 32">
                <a:extLst>
                  <a:ext uri="{FF2B5EF4-FFF2-40B4-BE49-F238E27FC236}">
                    <a16:creationId xmlns:a16="http://schemas.microsoft.com/office/drawing/2014/main" id="{694DCED6-1A01-4F14-986B-062D97C91E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96388" y="4525963"/>
                <a:ext cx="0" cy="53975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7" name="Line 84">
                <a:extLst>
                  <a:ext uri="{FF2B5EF4-FFF2-40B4-BE49-F238E27FC236}">
                    <a16:creationId xmlns:a16="http://schemas.microsoft.com/office/drawing/2014/main" id="{17007428-88C1-4505-98B5-D7F754BE79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762376" y="4519613"/>
                <a:ext cx="5554663" cy="0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Line 85">
                <a:extLst>
                  <a:ext uri="{FF2B5EF4-FFF2-40B4-BE49-F238E27FC236}">
                    <a16:creationId xmlns:a16="http://schemas.microsoft.com/office/drawing/2014/main" id="{E6B3D4A1-93BA-4C01-B013-ACC10BCE14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62376" y="1463675"/>
                <a:ext cx="0" cy="3055938"/>
              </a:xfrm>
              <a:prstGeom prst="line">
                <a:avLst/>
              </a:prstGeom>
              <a:noFill/>
              <a:ln w="14351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15" name="Rectangle 12">
            <a:extLst>
              <a:ext uri="{FF2B5EF4-FFF2-40B4-BE49-F238E27FC236}">
                <a16:creationId xmlns:a16="http://schemas.microsoft.com/office/drawing/2014/main" id="{AF5962EB-3C73-4924-BFCB-46101D2E8E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141" y="437673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B054FA74-E913-42DE-A76A-32E59F5F7A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7803" y="3781425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17" name="Rectangle 14">
            <a:extLst>
              <a:ext uri="{FF2B5EF4-FFF2-40B4-BE49-F238E27FC236}">
                <a16:creationId xmlns:a16="http://schemas.microsoft.com/office/drawing/2014/main" id="{E7037241-9208-4B8A-B70B-62D22E265C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7803" y="3195638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0</a:t>
            </a: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6478062A-66C3-4F54-8B7A-0026E0BE07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7803" y="260985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0</a:t>
            </a:r>
          </a:p>
        </p:txBody>
      </p:sp>
      <p:sp>
        <p:nvSpPr>
          <p:cNvPr id="19" name="Rectangle 16">
            <a:extLst>
              <a:ext uri="{FF2B5EF4-FFF2-40B4-BE49-F238E27FC236}">
                <a16:creationId xmlns:a16="http://schemas.microsoft.com/office/drawing/2014/main" id="{81F88285-3A9C-4654-A32F-BBB7883DC1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7803" y="2014538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0</a:t>
            </a:r>
          </a:p>
        </p:txBody>
      </p:sp>
      <p:sp>
        <p:nvSpPr>
          <p:cNvPr id="20" name="Rectangle 17">
            <a:extLst>
              <a:ext uri="{FF2B5EF4-FFF2-40B4-BE49-F238E27FC236}">
                <a16:creationId xmlns:a16="http://schemas.microsoft.com/office/drawing/2014/main" id="{41F08A55-A460-4904-88DC-8C1A62668F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1875" y="1428750"/>
            <a:ext cx="2548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0</a:t>
            </a: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1DA840E5-3C71-4DFB-A6B2-7F705E8F57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57036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6E9702D7-2F06-4456-8C54-50EEB84F5C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4861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</a:t>
            </a: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9AC51D8F-934F-4A12-9994-B599BA5DAF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4273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</a:t>
            </a: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AE68E15A-A2CA-4785-9FB8-77975C9984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5273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</a:p>
        </p:txBody>
      </p:sp>
      <p:sp>
        <p:nvSpPr>
          <p:cNvPr id="42" name="Rectangle 39">
            <a:extLst>
              <a:ext uri="{FF2B5EF4-FFF2-40B4-BE49-F238E27FC236}">
                <a16:creationId xmlns:a16="http://schemas.microsoft.com/office/drawing/2014/main" id="{6E5AF6C2-E549-4830-8CDB-871E17AEA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73098" y="461486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</a:t>
            </a: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C9992D43-EBFB-4281-862D-137288530E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0342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</a:t>
            </a: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22237A74-D18D-4387-B750-365E140C42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1342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2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34151251-4560-41BF-9D17-ED42A108D8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69167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4</a:t>
            </a: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E0DD3183-457A-4471-B16B-0B9E604F60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8579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6</a:t>
            </a:r>
          </a:p>
        </p:txBody>
      </p:sp>
      <p:sp>
        <p:nvSpPr>
          <p:cNvPr id="47" name="Rectangle 44">
            <a:extLst>
              <a:ext uri="{FF2B5EF4-FFF2-40B4-BE49-F238E27FC236}">
                <a16:creationId xmlns:a16="http://schemas.microsoft.com/office/drawing/2014/main" id="{33D78005-0346-459B-9181-CB27720AFC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9579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8</a:t>
            </a:r>
          </a:p>
        </p:txBody>
      </p:sp>
      <p:sp>
        <p:nvSpPr>
          <p:cNvPr id="48" name="Rectangle 45">
            <a:extLst>
              <a:ext uri="{FF2B5EF4-FFF2-40B4-BE49-F238E27FC236}">
                <a16:creationId xmlns:a16="http://schemas.microsoft.com/office/drawing/2014/main" id="{9E2CDF37-7CE6-4E29-97F0-EB5498CD2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7404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49" name="Rectangle 46">
            <a:extLst>
              <a:ext uri="{FF2B5EF4-FFF2-40B4-BE49-F238E27FC236}">
                <a16:creationId xmlns:a16="http://schemas.microsoft.com/office/drawing/2014/main" id="{BEF7A983-1443-47EE-AC56-BF5A5A430A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86817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2</a:t>
            </a:r>
          </a:p>
        </p:txBody>
      </p:sp>
      <p:sp>
        <p:nvSpPr>
          <p:cNvPr id="50" name="Rectangle 47">
            <a:extLst>
              <a:ext uri="{FF2B5EF4-FFF2-40B4-BE49-F238E27FC236}">
                <a16:creationId xmlns:a16="http://schemas.microsoft.com/office/drawing/2014/main" id="{C0CF51FA-B7E8-4E90-B07A-2D66684BA8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67817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4</a:t>
            </a:r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BA765D21-A37C-439F-888B-A9A60FE020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5642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6</a:t>
            </a:r>
          </a:p>
        </p:txBody>
      </p:sp>
      <p:sp>
        <p:nvSpPr>
          <p:cNvPr id="52" name="Rectangle 49">
            <a:extLst>
              <a:ext uri="{FF2B5EF4-FFF2-40B4-BE49-F238E27FC236}">
                <a16:creationId xmlns:a16="http://schemas.microsoft.com/office/drawing/2014/main" id="{C8853CCA-CB2D-4587-9E40-ACC592A1CE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25054" y="4614863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53" name="Rectangle 50">
            <a:extLst>
              <a:ext uri="{FF2B5EF4-FFF2-40B4-BE49-F238E27FC236}">
                <a16:creationId xmlns:a16="http://schemas.microsoft.com/office/drawing/2014/main" id="{F5D860BB-C648-49D2-A3EA-A470948C39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4867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73</a:t>
            </a:r>
          </a:p>
        </p:txBody>
      </p:sp>
      <p:sp>
        <p:nvSpPr>
          <p:cNvPr id="54" name="Rectangle 51">
            <a:extLst>
              <a:ext uri="{FF2B5EF4-FFF2-40B4-BE49-F238E27FC236}">
                <a16:creationId xmlns:a16="http://schemas.microsoft.com/office/drawing/2014/main" id="{CD20965F-B85B-47C5-908E-A13E650B3F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2692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4</a:t>
            </a:r>
          </a:p>
        </p:txBody>
      </p:sp>
      <p:sp>
        <p:nvSpPr>
          <p:cNvPr id="55" name="Rectangle 52">
            <a:extLst>
              <a:ext uri="{FF2B5EF4-FFF2-40B4-BE49-F238E27FC236}">
                <a16:creationId xmlns:a16="http://schemas.microsoft.com/office/drawing/2014/main" id="{059D1536-FEC3-40E0-ACF9-CFB3153FD2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210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8</a:t>
            </a:r>
          </a:p>
        </p:txBody>
      </p:sp>
      <p:sp>
        <p:nvSpPr>
          <p:cNvPr id="56" name="Rectangle 53">
            <a:extLst>
              <a:ext uri="{FF2B5EF4-FFF2-40B4-BE49-F238E27FC236}">
                <a16:creationId xmlns:a16="http://schemas.microsoft.com/office/drawing/2014/main" id="{22F035B5-2DA9-45B7-B722-FB53E3C26F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3104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6</a:t>
            </a:r>
          </a:p>
        </p:txBody>
      </p:sp>
      <p:sp>
        <p:nvSpPr>
          <p:cNvPr id="57" name="Rectangle 54">
            <a:extLst>
              <a:ext uri="{FF2B5EF4-FFF2-40B4-BE49-F238E27FC236}">
                <a16:creationId xmlns:a16="http://schemas.microsoft.com/office/drawing/2014/main" id="{445BF923-D1C5-4F09-89F1-76953B82CE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092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2</a:t>
            </a:r>
          </a:p>
        </p:txBody>
      </p:sp>
      <p:sp>
        <p:nvSpPr>
          <p:cNvPr id="58" name="Rectangle 55">
            <a:extLst>
              <a:ext uri="{FF2B5EF4-FFF2-40B4-BE49-F238E27FC236}">
                <a16:creationId xmlns:a16="http://schemas.microsoft.com/office/drawing/2014/main" id="{582C2D31-01BC-4CE9-9DE5-14F6AB03CD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0342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0</a:t>
            </a:r>
          </a:p>
        </p:txBody>
      </p:sp>
      <p:sp>
        <p:nvSpPr>
          <p:cNvPr id="59" name="Rectangle 56">
            <a:extLst>
              <a:ext uri="{FF2B5EF4-FFF2-40B4-BE49-F238E27FC236}">
                <a16:creationId xmlns:a16="http://schemas.microsoft.com/office/drawing/2014/main" id="{2B0D614E-BB1D-458D-9984-B62CBA06CD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91342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48</a:t>
            </a:r>
          </a:p>
        </p:txBody>
      </p:sp>
      <p:sp>
        <p:nvSpPr>
          <p:cNvPr id="60" name="Rectangle 57">
            <a:extLst>
              <a:ext uri="{FF2B5EF4-FFF2-40B4-BE49-F238E27FC236}">
                <a16:creationId xmlns:a16="http://schemas.microsoft.com/office/drawing/2014/main" id="{572BCAC6-DB9B-4BFD-92EA-8FCD0D1C22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69167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8</a:t>
            </a:r>
          </a:p>
        </p:txBody>
      </p:sp>
      <p:sp>
        <p:nvSpPr>
          <p:cNvPr id="61" name="Rectangle 58">
            <a:extLst>
              <a:ext uri="{FF2B5EF4-FFF2-40B4-BE49-F238E27FC236}">
                <a16:creationId xmlns:a16="http://schemas.microsoft.com/office/drawing/2014/main" id="{2CC3DD1E-207D-4358-A6E0-E2579FCB7D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857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8</a:t>
            </a:r>
          </a:p>
        </p:txBody>
      </p:sp>
      <p:sp>
        <p:nvSpPr>
          <p:cNvPr id="62" name="Rectangle 59">
            <a:extLst>
              <a:ext uri="{FF2B5EF4-FFF2-40B4-BE49-F238E27FC236}">
                <a16:creationId xmlns:a16="http://schemas.microsoft.com/office/drawing/2014/main" id="{AE2A1743-7E62-4FCA-8F88-389A21EA23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29579" y="5196601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7</a:t>
            </a:r>
          </a:p>
        </p:txBody>
      </p:sp>
      <p:sp>
        <p:nvSpPr>
          <p:cNvPr id="63" name="Rectangle 60">
            <a:extLst>
              <a:ext uri="{FF2B5EF4-FFF2-40B4-BE49-F238E27FC236}">
                <a16:creationId xmlns:a16="http://schemas.microsoft.com/office/drawing/2014/main" id="{29C32146-9642-4BFA-AA36-72125D9246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57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9</a:t>
            </a:r>
          </a:p>
        </p:txBody>
      </p:sp>
      <p:sp>
        <p:nvSpPr>
          <p:cNvPr id="64" name="Rectangle 61">
            <a:extLst>
              <a:ext uri="{FF2B5EF4-FFF2-40B4-BE49-F238E27FC236}">
                <a16:creationId xmlns:a16="http://schemas.microsoft.com/office/drawing/2014/main" id="{C7A6C7A2-77B5-4468-8912-C33D890F9C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8986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6</a:t>
            </a:r>
          </a:p>
        </p:txBody>
      </p:sp>
      <p:sp>
        <p:nvSpPr>
          <p:cNvPr id="65" name="Rectangle 62">
            <a:extLst>
              <a:ext uri="{FF2B5EF4-FFF2-40B4-BE49-F238E27FC236}">
                <a16:creationId xmlns:a16="http://schemas.microsoft.com/office/drawing/2014/main" id="{CAF87AA5-EC16-4AFB-8F91-74700C0402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09986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66" name="Rectangle 63">
            <a:extLst>
              <a:ext uri="{FF2B5EF4-FFF2-40B4-BE49-F238E27FC236}">
                <a16:creationId xmlns:a16="http://schemas.microsoft.com/office/drawing/2014/main" id="{D30D69F5-7BB6-41BC-A871-DE3652B565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7811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67" name="Rectangle 64">
            <a:extLst>
              <a:ext uri="{FF2B5EF4-FFF2-40B4-BE49-F238E27FC236}">
                <a16:creationId xmlns:a16="http://schemas.microsoft.com/office/drawing/2014/main" id="{A67DD674-3EBB-47FE-8533-285EAC81E9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67223" y="519660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68" name="Rectangle 65">
            <a:extLst>
              <a:ext uri="{FF2B5EF4-FFF2-40B4-BE49-F238E27FC236}">
                <a16:creationId xmlns:a16="http://schemas.microsoft.com/office/drawing/2014/main" id="{1F4BE0FB-102C-4B73-913F-9EF69AA05E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4867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20</a:t>
            </a:r>
          </a:p>
        </p:txBody>
      </p:sp>
      <p:sp>
        <p:nvSpPr>
          <p:cNvPr id="69" name="Rectangle 66">
            <a:extLst>
              <a:ext uri="{FF2B5EF4-FFF2-40B4-BE49-F238E27FC236}">
                <a16:creationId xmlns:a16="http://schemas.microsoft.com/office/drawing/2014/main" id="{6C0967E9-C605-4721-B101-2AD5BB98C1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2692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7</a:t>
            </a:r>
          </a:p>
        </p:txBody>
      </p:sp>
      <p:sp>
        <p:nvSpPr>
          <p:cNvPr id="70" name="Rectangle 67">
            <a:extLst>
              <a:ext uri="{FF2B5EF4-FFF2-40B4-BE49-F238E27FC236}">
                <a16:creationId xmlns:a16="http://schemas.microsoft.com/office/drawing/2014/main" id="{B2623A98-0862-49F8-A04C-F06E73D971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2104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5</a:t>
            </a:r>
          </a:p>
        </p:txBody>
      </p:sp>
      <p:sp>
        <p:nvSpPr>
          <p:cNvPr id="71" name="Rectangle 68">
            <a:extLst>
              <a:ext uri="{FF2B5EF4-FFF2-40B4-BE49-F238E27FC236}">
                <a16:creationId xmlns:a16="http://schemas.microsoft.com/office/drawing/2014/main" id="{EADD1831-94B6-4882-BFFE-5D49CB97F0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3104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5</a:t>
            </a:r>
          </a:p>
        </p:txBody>
      </p:sp>
      <p:sp>
        <p:nvSpPr>
          <p:cNvPr id="72" name="Rectangle 69">
            <a:extLst>
              <a:ext uri="{FF2B5EF4-FFF2-40B4-BE49-F238E27FC236}">
                <a16:creationId xmlns:a16="http://schemas.microsoft.com/office/drawing/2014/main" id="{1C339E94-5032-42C0-BABF-7A064E7322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30929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3</a:t>
            </a:r>
          </a:p>
        </p:txBody>
      </p:sp>
      <p:sp>
        <p:nvSpPr>
          <p:cNvPr id="73" name="Rectangle 70">
            <a:extLst>
              <a:ext uri="{FF2B5EF4-FFF2-40B4-BE49-F238E27FC236}">
                <a16:creationId xmlns:a16="http://schemas.microsoft.com/office/drawing/2014/main" id="{9FB6560C-D5F5-455E-861E-D9AFD6D76A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0342" y="5416382"/>
            <a:ext cx="16991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10</a:t>
            </a:r>
          </a:p>
        </p:txBody>
      </p:sp>
      <p:sp>
        <p:nvSpPr>
          <p:cNvPr id="74" name="Rectangle 71">
            <a:extLst>
              <a:ext uri="{FF2B5EF4-FFF2-40B4-BE49-F238E27FC236}">
                <a16:creationId xmlns:a16="http://schemas.microsoft.com/office/drawing/2014/main" id="{94A719B8-C897-4A41-88AA-EB49E31482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3511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8</a:t>
            </a:r>
          </a:p>
        </p:txBody>
      </p:sp>
      <p:sp>
        <p:nvSpPr>
          <p:cNvPr id="75" name="Rectangle 72">
            <a:extLst>
              <a:ext uri="{FF2B5EF4-FFF2-40B4-BE49-F238E27FC236}">
                <a16:creationId xmlns:a16="http://schemas.microsoft.com/office/drawing/2014/main" id="{C4615F1D-B5C0-4CE1-A35C-7EA6FBD8F7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1336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7</a:t>
            </a:r>
          </a:p>
        </p:txBody>
      </p:sp>
      <p:sp>
        <p:nvSpPr>
          <p:cNvPr id="76" name="Rectangle 73">
            <a:extLst>
              <a:ext uri="{FF2B5EF4-FFF2-40B4-BE49-F238E27FC236}">
                <a16:creationId xmlns:a16="http://schemas.microsoft.com/office/drawing/2014/main" id="{77D34ED4-D918-4E82-806B-770C63F494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90748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</a:t>
            </a:r>
          </a:p>
        </p:txBody>
      </p:sp>
      <p:sp>
        <p:nvSpPr>
          <p:cNvPr id="77" name="Rectangle 74">
            <a:extLst>
              <a:ext uri="{FF2B5EF4-FFF2-40B4-BE49-F238E27FC236}">
                <a16:creationId xmlns:a16="http://schemas.microsoft.com/office/drawing/2014/main" id="{C64A93F2-629B-4E2E-A314-E8DDA3A7C0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71748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5</a:t>
            </a:r>
          </a:p>
        </p:txBody>
      </p:sp>
      <p:sp>
        <p:nvSpPr>
          <p:cNvPr id="78" name="Rectangle 75">
            <a:extLst>
              <a:ext uri="{FF2B5EF4-FFF2-40B4-BE49-F238E27FC236}">
                <a16:creationId xmlns:a16="http://schemas.microsoft.com/office/drawing/2014/main" id="{EB0CAD3F-5A27-49D5-BDBD-382AA3FF87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9573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3</a:t>
            </a:r>
          </a:p>
        </p:txBody>
      </p:sp>
      <p:sp>
        <p:nvSpPr>
          <p:cNvPr id="79" name="Rectangle 76">
            <a:extLst>
              <a:ext uri="{FF2B5EF4-FFF2-40B4-BE49-F238E27FC236}">
                <a16:creationId xmlns:a16="http://schemas.microsoft.com/office/drawing/2014/main" id="{66970D63-BC30-42BB-8C4B-15EECE0BFC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8986" y="541638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>
                <a:ln>
                  <a:noFill/>
                </a:ln>
                <a:effectLst/>
                <a:latin typeface="Arial" panose="020B0604020202020204" pitchFamily="34" charset="0"/>
              </a:rPr>
              <a:t>0</a:t>
            </a:r>
          </a:p>
        </p:txBody>
      </p:sp>
      <p:sp>
        <p:nvSpPr>
          <p:cNvPr id="83" name="Rectangle 80">
            <a:extLst>
              <a:ext uri="{FF2B5EF4-FFF2-40B4-BE49-F238E27FC236}">
                <a16:creationId xmlns:a16="http://schemas.microsoft.com/office/drawing/2014/main" id="{10DD3A70-C336-4520-A33A-72B5DF8032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8960" y="5196601"/>
            <a:ext cx="116859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Standard-risk CA</a:t>
            </a:r>
          </a:p>
        </p:txBody>
      </p:sp>
      <p:sp>
        <p:nvSpPr>
          <p:cNvPr id="84" name="Rectangle 81">
            <a:extLst>
              <a:ext uri="{FF2B5EF4-FFF2-40B4-BE49-F238E27FC236}">
                <a16:creationId xmlns:a16="http://schemas.microsoft.com/office/drawing/2014/main" id="{8F4726DF-134C-45B6-966F-370AC20563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6737" y="5416382"/>
            <a:ext cx="86081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High-risk CA</a:t>
            </a:r>
          </a:p>
        </p:txBody>
      </p: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2D19E04B-47A1-49E5-86EB-FE54AC053A38}"/>
              </a:ext>
            </a:extLst>
          </p:cNvPr>
          <p:cNvGrpSpPr/>
          <p:nvPr/>
        </p:nvGrpSpPr>
        <p:grpSpPr>
          <a:xfrm>
            <a:off x="3783331" y="1501775"/>
            <a:ext cx="5211762" cy="1127125"/>
            <a:chOff x="3867151" y="1501775"/>
            <a:chExt cx="5211762" cy="1127125"/>
          </a:xfrm>
        </p:grpSpPr>
        <p:sp>
          <p:nvSpPr>
            <p:cNvPr id="91" name="Freeform 88">
              <a:extLst>
                <a:ext uri="{FF2B5EF4-FFF2-40B4-BE49-F238E27FC236}">
                  <a16:creationId xmlns:a16="http://schemas.microsoft.com/office/drawing/2014/main" id="{DBFC24D7-2DAA-419E-800D-2A478AEA38F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3026" y="1524000"/>
              <a:ext cx="5173663" cy="1082675"/>
            </a:xfrm>
            <a:custGeom>
              <a:avLst/>
              <a:gdLst>
                <a:gd name="T0" fmla="*/ 4 w 3259"/>
                <a:gd name="T1" fmla="*/ 0 h 682"/>
                <a:gd name="T2" fmla="*/ 104 w 3259"/>
                <a:gd name="T3" fmla="*/ 0 h 682"/>
                <a:gd name="T4" fmla="*/ 108 w 3259"/>
                <a:gd name="T5" fmla="*/ 22 h 682"/>
                <a:gd name="T6" fmla="*/ 112 w 3259"/>
                <a:gd name="T7" fmla="*/ 50 h 682"/>
                <a:gd name="T8" fmla="*/ 224 w 3259"/>
                <a:gd name="T9" fmla="*/ 50 h 682"/>
                <a:gd name="T10" fmla="*/ 338 w 3259"/>
                <a:gd name="T11" fmla="*/ 50 h 682"/>
                <a:gd name="T12" fmla="*/ 362 w 3259"/>
                <a:gd name="T13" fmla="*/ 80 h 682"/>
                <a:gd name="T14" fmla="*/ 435 w 3259"/>
                <a:gd name="T15" fmla="*/ 106 h 682"/>
                <a:gd name="T16" fmla="*/ 439 w 3259"/>
                <a:gd name="T17" fmla="*/ 138 h 682"/>
                <a:gd name="T18" fmla="*/ 459 w 3259"/>
                <a:gd name="T19" fmla="*/ 164 h 682"/>
                <a:gd name="T20" fmla="*/ 547 w 3259"/>
                <a:gd name="T21" fmla="*/ 197 h 682"/>
                <a:gd name="T22" fmla="*/ 777 w 3259"/>
                <a:gd name="T23" fmla="*/ 197 h 682"/>
                <a:gd name="T24" fmla="*/ 801 w 3259"/>
                <a:gd name="T25" fmla="*/ 223 h 682"/>
                <a:gd name="T26" fmla="*/ 909 w 3259"/>
                <a:gd name="T27" fmla="*/ 223 h 682"/>
                <a:gd name="T28" fmla="*/ 969 w 3259"/>
                <a:gd name="T29" fmla="*/ 253 h 682"/>
                <a:gd name="T30" fmla="*/ 1128 w 3259"/>
                <a:gd name="T31" fmla="*/ 285 h 682"/>
                <a:gd name="T32" fmla="*/ 1244 w 3259"/>
                <a:gd name="T33" fmla="*/ 315 h 682"/>
                <a:gd name="T34" fmla="*/ 1486 w 3259"/>
                <a:gd name="T35" fmla="*/ 315 h 682"/>
                <a:gd name="T36" fmla="*/ 1536 w 3259"/>
                <a:gd name="T37" fmla="*/ 349 h 682"/>
                <a:gd name="T38" fmla="*/ 1538 w 3259"/>
                <a:gd name="T39" fmla="*/ 381 h 682"/>
                <a:gd name="T40" fmla="*/ 1624 w 3259"/>
                <a:gd name="T41" fmla="*/ 381 h 682"/>
                <a:gd name="T42" fmla="*/ 1634 w 3259"/>
                <a:gd name="T43" fmla="*/ 415 h 682"/>
                <a:gd name="T44" fmla="*/ 1646 w 3259"/>
                <a:gd name="T45" fmla="*/ 449 h 682"/>
                <a:gd name="T46" fmla="*/ 1658 w 3259"/>
                <a:gd name="T47" fmla="*/ 449 h 682"/>
                <a:gd name="T48" fmla="*/ 1678 w 3259"/>
                <a:gd name="T49" fmla="*/ 449 h 682"/>
                <a:gd name="T50" fmla="*/ 1770 w 3259"/>
                <a:gd name="T51" fmla="*/ 489 h 682"/>
                <a:gd name="T52" fmla="*/ 1793 w 3259"/>
                <a:gd name="T53" fmla="*/ 489 h 682"/>
                <a:gd name="T54" fmla="*/ 1875 w 3259"/>
                <a:gd name="T55" fmla="*/ 489 h 682"/>
                <a:gd name="T56" fmla="*/ 1889 w 3259"/>
                <a:gd name="T57" fmla="*/ 489 h 682"/>
                <a:gd name="T58" fmla="*/ 1923 w 3259"/>
                <a:gd name="T59" fmla="*/ 489 h 682"/>
                <a:gd name="T60" fmla="*/ 1959 w 3259"/>
                <a:gd name="T61" fmla="*/ 489 h 682"/>
                <a:gd name="T62" fmla="*/ 1981 w 3259"/>
                <a:gd name="T63" fmla="*/ 489 h 682"/>
                <a:gd name="T64" fmla="*/ 2005 w 3259"/>
                <a:gd name="T65" fmla="*/ 489 h 682"/>
                <a:gd name="T66" fmla="*/ 2105 w 3259"/>
                <a:gd name="T67" fmla="*/ 489 h 682"/>
                <a:gd name="T68" fmla="*/ 2181 w 3259"/>
                <a:gd name="T69" fmla="*/ 489 h 682"/>
                <a:gd name="T70" fmla="*/ 2277 w 3259"/>
                <a:gd name="T71" fmla="*/ 489 h 682"/>
                <a:gd name="T72" fmla="*/ 2319 w 3259"/>
                <a:gd name="T73" fmla="*/ 489 h 682"/>
                <a:gd name="T74" fmla="*/ 2343 w 3259"/>
                <a:gd name="T75" fmla="*/ 489 h 682"/>
                <a:gd name="T76" fmla="*/ 2447 w 3259"/>
                <a:gd name="T77" fmla="*/ 489 h 682"/>
                <a:gd name="T78" fmla="*/ 2612 w 3259"/>
                <a:gd name="T79" fmla="*/ 489 h 682"/>
                <a:gd name="T80" fmla="*/ 2640 w 3259"/>
                <a:gd name="T81" fmla="*/ 682 h 682"/>
                <a:gd name="T82" fmla="*/ 3134 w 3259"/>
                <a:gd name="T83" fmla="*/ 682 h 682"/>
                <a:gd name="T84" fmla="*/ 3259 w 3259"/>
                <a:gd name="T85" fmla="*/ 682 h 6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3259" h="682">
                  <a:moveTo>
                    <a:pt x="0" y="0"/>
                  </a:moveTo>
                  <a:lnTo>
                    <a:pt x="4" y="0"/>
                  </a:lnTo>
                  <a:lnTo>
                    <a:pt x="62" y="0"/>
                  </a:lnTo>
                  <a:lnTo>
                    <a:pt x="104" y="0"/>
                  </a:lnTo>
                  <a:lnTo>
                    <a:pt x="104" y="22"/>
                  </a:lnTo>
                  <a:lnTo>
                    <a:pt x="108" y="22"/>
                  </a:lnTo>
                  <a:lnTo>
                    <a:pt x="108" y="50"/>
                  </a:lnTo>
                  <a:lnTo>
                    <a:pt x="112" y="50"/>
                  </a:lnTo>
                  <a:lnTo>
                    <a:pt x="220" y="50"/>
                  </a:lnTo>
                  <a:lnTo>
                    <a:pt x="224" y="50"/>
                  </a:lnTo>
                  <a:lnTo>
                    <a:pt x="336" y="50"/>
                  </a:lnTo>
                  <a:lnTo>
                    <a:pt x="338" y="50"/>
                  </a:lnTo>
                  <a:lnTo>
                    <a:pt x="338" y="80"/>
                  </a:lnTo>
                  <a:lnTo>
                    <a:pt x="362" y="80"/>
                  </a:lnTo>
                  <a:lnTo>
                    <a:pt x="362" y="106"/>
                  </a:lnTo>
                  <a:lnTo>
                    <a:pt x="435" y="106"/>
                  </a:lnTo>
                  <a:lnTo>
                    <a:pt x="435" y="138"/>
                  </a:lnTo>
                  <a:lnTo>
                    <a:pt x="439" y="138"/>
                  </a:lnTo>
                  <a:lnTo>
                    <a:pt x="439" y="164"/>
                  </a:lnTo>
                  <a:lnTo>
                    <a:pt x="459" y="164"/>
                  </a:lnTo>
                  <a:lnTo>
                    <a:pt x="547" y="164"/>
                  </a:lnTo>
                  <a:lnTo>
                    <a:pt x="547" y="197"/>
                  </a:lnTo>
                  <a:lnTo>
                    <a:pt x="693" y="197"/>
                  </a:lnTo>
                  <a:lnTo>
                    <a:pt x="777" y="197"/>
                  </a:lnTo>
                  <a:lnTo>
                    <a:pt x="801" y="197"/>
                  </a:lnTo>
                  <a:lnTo>
                    <a:pt x="801" y="223"/>
                  </a:lnTo>
                  <a:lnTo>
                    <a:pt x="877" y="223"/>
                  </a:lnTo>
                  <a:lnTo>
                    <a:pt x="909" y="223"/>
                  </a:lnTo>
                  <a:lnTo>
                    <a:pt x="909" y="253"/>
                  </a:lnTo>
                  <a:lnTo>
                    <a:pt x="969" y="253"/>
                  </a:lnTo>
                  <a:lnTo>
                    <a:pt x="969" y="285"/>
                  </a:lnTo>
                  <a:lnTo>
                    <a:pt x="1128" y="285"/>
                  </a:lnTo>
                  <a:lnTo>
                    <a:pt x="1128" y="315"/>
                  </a:lnTo>
                  <a:lnTo>
                    <a:pt x="1244" y="315"/>
                  </a:lnTo>
                  <a:lnTo>
                    <a:pt x="1320" y="315"/>
                  </a:lnTo>
                  <a:lnTo>
                    <a:pt x="1486" y="315"/>
                  </a:lnTo>
                  <a:lnTo>
                    <a:pt x="1536" y="315"/>
                  </a:lnTo>
                  <a:lnTo>
                    <a:pt x="1536" y="349"/>
                  </a:lnTo>
                  <a:lnTo>
                    <a:pt x="1538" y="349"/>
                  </a:lnTo>
                  <a:lnTo>
                    <a:pt x="1538" y="381"/>
                  </a:lnTo>
                  <a:lnTo>
                    <a:pt x="1566" y="381"/>
                  </a:lnTo>
                  <a:lnTo>
                    <a:pt x="1624" y="381"/>
                  </a:lnTo>
                  <a:lnTo>
                    <a:pt x="1624" y="415"/>
                  </a:lnTo>
                  <a:lnTo>
                    <a:pt x="1634" y="415"/>
                  </a:lnTo>
                  <a:lnTo>
                    <a:pt x="1634" y="449"/>
                  </a:lnTo>
                  <a:lnTo>
                    <a:pt x="1646" y="449"/>
                  </a:lnTo>
                  <a:lnTo>
                    <a:pt x="1650" y="449"/>
                  </a:lnTo>
                  <a:lnTo>
                    <a:pt x="1658" y="449"/>
                  </a:lnTo>
                  <a:lnTo>
                    <a:pt x="1674" y="449"/>
                  </a:lnTo>
                  <a:lnTo>
                    <a:pt x="1678" y="449"/>
                  </a:lnTo>
                  <a:lnTo>
                    <a:pt x="1678" y="489"/>
                  </a:lnTo>
                  <a:lnTo>
                    <a:pt x="1770" y="489"/>
                  </a:lnTo>
                  <a:lnTo>
                    <a:pt x="1778" y="489"/>
                  </a:lnTo>
                  <a:lnTo>
                    <a:pt x="1793" y="489"/>
                  </a:lnTo>
                  <a:lnTo>
                    <a:pt x="1871" y="489"/>
                  </a:lnTo>
                  <a:lnTo>
                    <a:pt x="1875" y="489"/>
                  </a:lnTo>
                  <a:lnTo>
                    <a:pt x="1881" y="489"/>
                  </a:lnTo>
                  <a:lnTo>
                    <a:pt x="1889" y="489"/>
                  </a:lnTo>
                  <a:lnTo>
                    <a:pt x="1901" y="489"/>
                  </a:lnTo>
                  <a:lnTo>
                    <a:pt x="1923" y="489"/>
                  </a:lnTo>
                  <a:lnTo>
                    <a:pt x="1927" y="489"/>
                  </a:lnTo>
                  <a:lnTo>
                    <a:pt x="1959" y="489"/>
                  </a:lnTo>
                  <a:lnTo>
                    <a:pt x="1967" y="489"/>
                  </a:lnTo>
                  <a:lnTo>
                    <a:pt x="1981" y="489"/>
                  </a:lnTo>
                  <a:lnTo>
                    <a:pt x="1985" y="489"/>
                  </a:lnTo>
                  <a:lnTo>
                    <a:pt x="2005" y="489"/>
                  </a:lnTo>
                  <a:lnTo>
                    <a:pt x="2085" y="489"/>
                  </a:lnTo>
                  <a:lnTo>
                    <a:pt x="2105" y="489"/>
                  </a:lnTo>
                  <a:lnTo>
                    <a:pt x="2147" y="489"/>
                  </a:lnTo>
                  <a:lnTo>
                    <a:pt x="2181" y="489"/>
                  </a:lnTo>
                  <a:lnTo>
                    <a:pt x="2201" y="489"/>
                  </a:lnTo>
                  <a:lnTo>
                    <a:pt x="2277" y="489"/>
                  </a:lnTo>
                  <a:lnTo>
                    <a:pt x="2315" y="489"/>
                  </a:lnTo>
                  <a:lnTo>
                    <a:pt x="2319" y="489"/>
                  </a:lnTo>
                  <a:lnTo>
                    <a:pt x="2339" y="489"/>
                  </a:lnTo>
                  <a:lnTo>
                    <a:pt x="2343" y="489"/>
                  </a:lnTo>
                  <a:lnTo>
                    <a:pt x="2365" y="489"/>
                  </a:lnTo>
                  <a:lnTo>
                    <a:pt x="2447" y="489"/>
                  </a:lnTo>
                  <a:lnTo>
                    <a:pt x="2566" y="489"/>
                  </a:lnTo>
                  <a:lnTo>
                    <a:pt x="2612" y="489"/>
                  </a:lnTo>
                  <a:lnTo>
                    <a:pt x="2612" y="682"/>
                  </a:lnTo>
                  <a:lnTo>
                    <a:pt x="2640" y="682"/>
                  </a:lnTo>
                  <a:lnTo>
                    <a:pt x="2724" y="682"/>
                  </a:lnTo>
                  <a:lnTo>
                    <a:pt x="3134" y="682"/>
                  </a:lnTo>
                  <a:lnTo>
                    <a:pt x="3147" y="682"/>
                  </a:lnTo>
                  <a:lnTo>
                    <a:pt x="3259" y="682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72" name="Group 171">
              <a:extLst>
                <a:ext uri="{FF2B5EF4-FFF2-40B4-BE49-F238E27FC236}">
                  <a16:creationId xmlns:a16="http://schemas.microsoft.com/office/drawing/2014/main" id="{698D2762-61FF-446C-B1ED-7C6E060A54FA}"/>
                </a:ext>
              </a:extLst>
            </p:cNvPr>
            <p:cNvGrpSpPr/>
            <p:nvPr/>
          </p:nvGrpSpPr>
          <p:grpSpPr>
            <a:xfrm>
              <a:off x="3867151" y="1501775"/>
              <a:ext cx="5211762" cy="1127125"/>
              <a:chOff x="3867151" y="1501775"/>
              <a:chExt cx="5211762" cy="1127125"/>
            </a:xfrm>
          </p:grpSpPr>
          <p:sp>
            <p:nvSpPr>
              <p:cNvPr id="92" name="Line 89">
                <a:extLst>
                  <a:ext uri="{FF2B5EF4-FFF2-40B4-BE49-F238E27FC236}">
                    <a16:creationId xmlns:a16="http://schemas.microsoft.com/office/drawing/2014/main" id="{654204A4-138F-472C-9E4F-9B412E1572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79851" y="1524000"/>
                <a:ext cx="222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Line 90">
                <a:extLst>
                  <a:ext uri="{FF2B5EF4-FFF2-40B4-BE49-F238E27FC236}">
                    <a16:creationId xmlns:a16="http://schemas.microsoft.com/office/drawing/2014/main" id="{55473629-B8A7-4043-B795-F6B7238139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9376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Line 91">
                <a:extLst>
                  <a:ext uri="{FF2B5EF4-FFF2-40B4-BE49-F238E27FC236}">
                    <a16:creationId xmlns:a16="http://schemas.microsoft.com/office/drawing/2014/main" id="{EA929A4D-AC02-4A99-B2DE-DC254ABA56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67151" y="1524000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Line 92">
                <a:extLst>
                  <a:ext uri="{FF2B5EF4-FFF2-40B4-BE49-F238E27FC236}">
                    <a16:creationId xmlns:a16="http://schemas.microsoft.com/office/drawing/2014/main" id="{AAE5AD7E-0978-40F9-979E-408A492BA8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9376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Line 93">
                <a:extLst>
                  <a:ext uri="{FF2B5EF4-FFF2-40B4-BE49-F238E27FC236}">
                    <a16:creationId xmlns:a16="http://schemas.microsoft.com/office/drawing/2014/main" id="{D263F352-9CEA-4827-AC14-0F1B4B2BF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1451" y="1501775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Line 94">
                <a:extLst>
                  <a:ext uri="{FF2B5EF4-FFF2-40B4-BE49-F238E27FC236}">
                    <a16:creationId xmlns:a16="http://schemas.microsoft.com/office/drawing/2014/main" id="{FCD711FE-B4B8-4C30-8143-8AEF5ACAED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48126" y="1603375"/>
                <a:ext cx="2540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Line 95">
                <a:extLst>
                  <a:ext uri="{FF2B5EF4-FFF2-40B4-BE49-F238E27FC236}">
                    <a16:creationId xmlns:a16="http://schemas.microsoft.com/office/drawing/2014/main" id="{B121BBD5-5C48-40AD-97AE-78B50DA023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0826" y="1590675"/>
                <a:ext cx="0" cy="2540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9" name="Line 96">
                <a:extLst>
                  <a:ext uri="{FF2B5EF4-FFF2-40B4-BE49-F238E27FC236}">
                    <a16:creationId xmlns:a16="http://schemas.microsoft.com/office/drawing/2014/main" id="{1285F032-AE29-42FA-99CE-39DC6AE24A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8601" y="160337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Line 97">
                <a:extLst>
                  <a:ext uri="{FF2B5EF4-FFF2-40B4-BE49-F238E27FC236}">
                    <a16:creationId xmlns:a16="http://schemas.microsoft.com/office/drawing/2014/main" id="{D3839EDA-53F5-4290-AA17-BDB01327B9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0826" y="15779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Line 98">
                <a:extLst>
                  <a:ext uri="{FF2B5EF4-FFF2-40B4-BE49-F238E27FC236}">
                    <a16:creationId xmlns:a16="http://schemas.microsoft.com/office/drawing/2014/main" id="{CF008CB7-EE56-4C3F-B63B-187AB6EB36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2276" y="15779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Line 99">
                <a:extLst>
                  <a:ext uri="{FF2B5EF4-FFF2-40B4-BE49-F238E27FC236}">
                    <a16:creationId xmlns:a16="http://schemas.microsoft.com/office/drawing/2014/main" id="{246955DD-B6D5-4310-9013-1B5B47331B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8626" y="15779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Line 100">
                <a:extLst>
                  <a:ext uri="{FF2B5EF4-FFF2-40B4-BE49-F238E27FC236}">
                    <a16:creationId xmlns:a16="http://schemas.microsoft.com/office/drawing/2014/main" id="{E369B6A7-DBDA-41B2-B5EB-114EA432FA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391026" y="1603375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Line 101">
                <a:extLst>
                  <a:ext uri="{FF2B5EF4-FFF2-40B4-BE49-F238E27FC236}">
                    <a16:creationId xmlns:a16="http://schemas.microsoft.com/office/drawing/2014/main" id="{FD35729B-ED18-4119-B7BD-FE26BD826C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16426" y="15779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Line 102">
                <a:extLst>
                  <a:ext uri="{FF2B5EF4-FFF2-40B4-BE49-F238E27FC236}">
                    <a16:creationId xmlns:a16="http://schemas.microsoft.com/office/drawing/2014/main" id="{E2A6A81D-FF71-4358-ABDD-00DA313B30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11688" y="1762125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Line 103">
                <a:extLst>
                  <a:ext uri="{FF2B5EF4-FFF2-40B4-BE49-F238E27FC236}">
                    <a16:creationId xmlns:a16="http://schemas.microsoft.com/office/drawing/2014/main" id="{2630E9E7-08BA-4C68-9530-C5F5030D9C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83163" y="181133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Line 104">
                <a:extLst>
                  <a:ext uri="{FF2B5EF4-FFF2-40B4-BE49-F238E27FC236}">
                    <a16:creationId xmlns:a16="http://schemas.microsoft.com/office/drawing/2014/main" id="{7A9906FB-C43B-4DE2-8A51-9F83C61EEB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16513" y="181133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Line 105">
                <a:extLst>
                  <a:ext uri="{FF2B5EF4-FFF2-40B4-BE49-F238E27FC236}">
                    <a16:creationId xmlns:a16="http://schemas.microsoft.com/office/drawing/2014/main" id="{394B6AEA-FC64-459B-A945-9755B88F34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75263" y="18557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Line 106">
                <a:extLst>
                  <a:ext uri="{FF2B5EF4-FFF2-40B4-BE49-F238E27FC236}">
                    <a16:creationId xmlns:a16="http://schemas.microsoft.com/office/drawing/2014/main" id="{68952B8D-082D-49B0-B457-D0722588F7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57876" y="20018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" name="Line 107">
                <a:extLst>
                  <a:ext uri="{FF2B5EF4-FFF2-40B4-BE49-F238E27FC236}">
                    <a16:creationId xmlns:a16="http://schemas.microsoft.com/office/drawing/2014/main" id="{47B753AA-3C64-42E6-8120-61326B3E7D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78526" y="20018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Line 108">
                <a:extLst>
                  <a:ext uri="{FF2B5EF4-FFF2-40B4-BE49-F238E27FC236}">
                    <a16:creationId xmlns:a16="http://schemas.microsoft.com/office/drawing/2014/main" id="{23B0E233-0A31-4AF4-8391-3FDD8A2A85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42051" y="200183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" name="Line 109">
                <a:extLst>
                  <a:ext uri="{FF2B5EF4-FFF2-40B4-BE49-F238E27FC236}">
                    <a16:creationId xmlns:a16="http://schemas.microsoft.com/office/drawing/2014/main" id="{DD1DA470-5EF3-4ED3-8081-CA2EA2F854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69051" y="210661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" name="Line 110">
                <a:extLst>
                  <a:ext uri="{FF2B5EF4-FFF2-40B4-BE49-F238E27FC236}">
                    <a16:creationId xmlns:a16="http://schemas.microsoft.com/office/drawing/2014/main" id="{D041A322-A2AC-423D-A0BC-A2D78B95F5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438901" y="2182813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" name="Line 111">
                <a:extLst>
                  <a:ext uri="{FF2B5EF4-FFF2-40B4-BE49-F238E27FC236}">
                    <a16:creationId xmlns:a16="http://schemas.microsoft.com/office/drawing/2014/main" id="{DFE7EB44-0F30-439E-B8C9-E6DDAB7658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61126" y="2160588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" name="Line 112">
                <a:extLst>
                  <a:ext uri="{FF2B5EF4-FFF2-40B4-BE49-F238E27FC236}">
                    <a16:creationId xmlns:a16="http://schemas.microsoft.com/office/drawing/2014/main" id="{5E9D893F-7DDB-4490-8D87-720A6BD9B5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473826" y="2236788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" name="Line 113">
                <a:extLst>
                  <a:ext uri="{FF2B5EF4-FFF2-40B4-BE49-F238E27FC236}">
                    <a16:creationId xmlns:a16="http://schemas.microsoft.com/office/drawing/2014/main" id="{5D59B1D9-7714-4F43-85D6-DA5D87E3A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15101" y="2236788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" name="Line 114">
                <a:extLst>
                  <a:ext uri="{FF2B5EF4-FFF2-40B4-BE49-F238E27FC236}">
                    <a16:creationId xmlns:a16="http://schemas.microsoft.com/office/drawing/2014/main" id="{4FE0CDD8-8F24-4F35-9CD0-0CD29D823A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96051" y="22145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" name="Line 115">
                <a:extLst>
                  <a:ext uri="{FF2B5EF4-FFF2-40B4-BE49-F238E27FC236}">
                    <a16:creationId xmlns:a16="http://schemas.microsoft.com/office/drawing/2014/main" id="{7C84A9E2-F949-4BDF-9C52-ABA6C9E7E9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02401" y="22145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" name="Line 116">
                <a:extLst>
                  <a:ext uri="{FF2B5EF4-FFF2-40B4-BE49-F238E27FC236}">
                    <a16:creationId xmlns:a16="http://schemas.microsoft.com/office/drawing/2014/main" id="{A171C97F-EC88-4ACA-9CA9-F724B94F76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15101" y="22145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Line 117">
                <a:extLst>
                  <a:ext uri="{FF2B5EF4-FFF2-40B4-BE49-F238E27FC236}">
                    <a16:creationId xmlns:a16="http://schemas.microsoft.com/office/drawing/2014/main" id="{2BBA850A-E7C9-411A-A14B-910C4B3647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0501" y="221456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Line 118">
                <a:extLst>
                  <a:ext uri="{FF2B5EF4-FFF2-40B4-BE49-F238E27FC236}">
                    <a16:creationId xmlns:a16="http://schemas.microsoft.com/office/drawing/2014/main" id="{1D9958D5-9B34-4F98-8468-593105FE80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92901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Line 119">
                <a:extLst>
                  <a:ext uri="{FF2B5EF4-FFF2-40B4-BE49-F238E27FC236}">
                    <a16:creationId xmlns:a16="http://schemas.microsoft.com/office/drawing/2014/main" id="{2E3194E4-DC69-4099-9DDD-9D6FF7BAA7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05601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" name="Line 120">
                <a:extLst>
                  <a:ext uri="{FF2B5EF4-FFF2-40B4-BE49-F238E27FC236}">
                    <a16:creationId xmlns:a16="http://schemas.microsoft.com/office/drawing/2014/main" id="{4E05A2E7-56B8-4ECB-9170-486869FC73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294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" name="Line 121">
                <a:extLst>
                  <a:ext uri="{FF2B5EF4-FFF2-40B4-BE49-F238E27FC236}">
                    <a16:creationId xmlns:a16="http://schemas.microsoft.com/office/drawing/2014/main" id="{BCE15850-FF56-4392-9338-324A140CA4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532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5" name="Line 122">
                <a:extLst>
                  <a:ext uri="{FF2B5EF4-FFF2-40B4-BE49-F238E27FC236}">
                    <a16:creationId xmlns:a16="http://schemas.microsoft.com/office/drawing/2014/main" id="{2D843DBD-69B5-422D-93F5-D7E10F0477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5958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6" name="Line 123">
                <a:extLst>
                  <a:ext uri="{FF2B5EF4-FFF2-40B4-BE49-F238E27FC236}">
                    <a16:creationId xmlns:a16="http://schemas.microsoft.com/office/drawing/2014/main" id="{7A8F403A-693F-4DAC-A8E5-E7A8407432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691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7" name="Line 124">
                <a:extLst>
                  <a:ext uri="{FF2B5EF4-FFF2-40B4-BE49-F238E27FC236}">
                    <a16:creationId xmlns:a16="http://schemas.microsoft.com/office/drawing/2014/main" id="{0744D688-FFC3-4C99-A513-B18A621359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818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8" name="Line 125">
                <a:extLst>
                  <a:ext uri="{FF2B5EF4-FFF2-40B4-BE49-F238E27FC236}">
                    <a16:creationId xmlns:a16="http://schemas.microsoft.com/office/drawing/2014/main" id="{ACE5298C-E0B1-41B1-8560-BCDC5835BE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08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" name="Line 126">
                <a:extLst>
                  <a:ext uri="{FF2B5EF4-FFF2-40B4-BE49-F238E27FC236}">
                    <a16:creationId xmlns:a16="http://schemas.microsoft.com/office/drawing/2014/main" id="{69B154CD-FBA7-4EC9-BF7B-7A634DAEBC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3578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" name="Line 127">
                <a:extLst>
                  <a:ext uri="{FF2B5EF4-FFF2-40B4-BE49-F238E27FC236}">
                    <a16:creationId xmlns:a16="http://schemas.microsoft.com/office/drawing/2014/main" id="{56CD743E-C604-4E99-8783-BF5BBFFB4A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421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" name="Line 128">
                <a:extLst>
                  <a:ext uri="{FF2B5EF4-FFF2-40B4-BE49-F238E27FC236}">
                    <a16:creationId xmlns:a16="http://schemas.microsoft.com/office/drawing/2014/main" id="{567D281D-2A41-4CC1-AC62-B9B390F7FB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929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" name="Line 129">
                <a:extLst>
                  <a:ext uri="{FF2B5EF4-FFF2-40B4-BE49-F238E27FC236}">
                    <a16:creationId xmlns:a16="http://schemas.microsoft.com/office/drawing/2014/main" id="{CA614CE2-2329-4E0E-A234-5BE456BEAE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929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" name="Line 130">
                <a:extLst>
                  <a:ext uri="{FF2B5EF4-FFF2-40B4-BE49-F238E27FC236}">
                    <a16:creationId xmlns:a16="http://schemas.microsoft.com/office/drawing/2014/main" id="{2360987E-E663-491E-8B06-D848F88BEA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056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" name="Line 131">
                <a:extLst>
                  <a:ext uri="{FF2B5EF4-FFF2-40B4-BE49-F238E27FC236}">
                    <a16:creationId xmlns:a16="http://schemas.microsoft.com/office/drawing/2014/main" id="{6BE53E2A-D839-4785-ADC8-2ABF3A26C4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278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" name="Line 132">
                <a:extLst>
                  <a:ext uri="{FF2B5EF4-FFF2-40B4-BE49-F238E27FC236}">
                    <a16:creationId xmlns:a16="http://schemas.microsoft.com/office/drawing/2014/main" id="{DB1CA4D3-9401-4E87-AB22-F5BF4162D3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342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" name="Line 133">
                <a:extLst>
                  <a:ext uri="{FF2B5EF4-FFF2-40B4-BE49-F238E27FC236}">
                    <a16:creationId xmlns:a16="http://schemas.microsoft.com/office/drawing/2014/main" id="{17ADBA5D-77EB-443C-8F5C-C66F14B8C8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659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" name="Line 134">
                <a:extLst>
                  <a:ext uri="{FF2B5EF4-FFF2-40B4-BE49-F238E27FC236}">
                    <a16:creationId xmlns:a16="http://schemas.microsoft.com/office/drawing/2014/main" id="{F3EBFEF0-5716-41CD-A0C6-2EF79F0D0A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929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" name="Line 135">
                <a:extLst>
                  <a:ext uri="{FF2B5EF4-FFF2-40B4-BE49-F238E27FC236}">
                    <a16:creationId xmlns:a16="http://schemas.microsoft.com/office/drawing/2014/main" id="{51FAE66E-8FF5-427A-83F3-D0F1FE7726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247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" name="Line 136">
                <a:extLst>
                  <a:ext uri="{FF2B5EF4-FFF2-40B4-BE49-F238E27FC236}">
                    <a16:creationId xmlns:a16="http://schemas.microsoft.com/office/drawing/2014/main" id="{2BBCD58B-D287-48F1-A725-C17197A671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9138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" name="Line 137">
                <a:extLst>
                  <a:ext uri="{FF2B5EF4-FFF2-40B4-BE49-F238E27FC236}">
                    <a16:creationId xmlns:a16="http://schemas.microsoft.com/office/drawing/2014/main" id="{EE1DB40E-0271-450E-B1C9-3EDAB102EE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53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" name="Line 138">
                <a:extLst>
                  <a:ext uri="{FF2B5EF4-FFF2-40B4-BE49-F238E27FC236}">
                    <a16:creationId xmlns:a16="http://schemas.microsoft.com/office/drawing/2014/main" id="{42CC7A84-9015-4F6B-AAD8-8A8968D0BB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7711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" name="Line 139">
                <a:extLst>
                  <a:ext uri="{FF2B5EF4-FFF2-40B4-BE49-F238E27FC236}">
                    <a16:creationId xmlns:a16="http://schemas.microsoft.com/office/drawing/2014/main" id="{ABA36200-8747-454C-93E8-ECC91DD696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977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" name="Line 140">
                <a:extLst>
                  <a:ext uri="{FF2B5EF4-FFF2-40B4-BE49-F238E27FC236}">
                    <a16:creationId xmlns:a16="http://schemas.microsoft.com/office/drawing/2014/main" id="{15B4ECE5-0C25-4F61-96D8-4D301142A6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5808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" name="Line 141">
                <a:extLst>
                  <a:ext uri="{FF2B5EF4-FFF2-40B4-BE49-F238E27FC236}">
                    <a16:creationId xmlns:a16="http://schemas.microsoft.com/office/drawing/2014/main" id="{D42BC02C-02D0-4377-B03A-676F0B7E34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644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" name="Line 142">
                <a:extLst>
                  <a:ext uri="{FF2B5EF4-FFF2-40B4-BE49-F238E27FC236}">
                    <a16:creationId xmlns:a16="http://schemas.microsoft.com/office/drawing/2014/main" id="{C490596D-84E3-4158-A00C-FA6D271EF7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9618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" name="Line 143">
                <a:extLst>
                  <a:ext uri="{FF2B5EF4-FFF2-40B4-BE49-F238E27FC236}">
                    <a16:creationId xmlns:a16="http://schemas.microsoft.com/office/drawing/2014/main" id="{982198A0-9035-413D-9C81-7CACF2557E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025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" name="Line 144">
                <a:extLst>
                  <a:ext uri="{FF2B5EF4-FFF2-40B4-BE49-F238E27FC236}">
                    <a16:creationId xmlns:a16="http://schemas.microsoft.com/office/drawing/2014/main" id="{2224FD25-D141-4031-9835-CF86E66E9A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37463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8" name="Line 145">
                <a:extLst>
                  <a:ext uri="{FF2B5EF4-FFF2-40B4-BE49-F238E27FC236}">
                    <a16:creationId xmlns:a16="http://schemas.microsoft.com/office/drawing/2014/main" id="{D0F7E644-D957-4DDD-AB96-F0EAEE1FE1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67638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9" name="Line 146">
                <a:extLst>
                  <a:ext uri="{FF2B5EF4-FFF2-40B4-BE49-F238E27FC236}">
                    <a16:creationId xmlns:a16="http://schemas.microsoft.com/office/drawing/2014/main" id="{406DDB88-9533-41E6-94C4-3C46DC22A8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56551" y="22748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0" name="Line 147">
                <a:extLst>
                  <a:ext uri="{FF2B5EF4-FFF2-40B4-BE49-F238E27FC236}">
                    <a16:creationId xmlns:a16="http://schemas.microsoft.com/office/drawing/2014/main" id="{C05A17F3-3FBE-4105-8329-AF3261DFEB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74026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1" name="Line 148">
                <a:extLst>
                  <a:ext uri="{FF2B5EF4-FFF2-40B4-BE49-F238E27FC236}">
                    <a16:creationId xmlns:a16="http://schemas.microsoft.com/office/drawing/2014/main" id="{9A31D075-7B18-41EF-AB36-CAB76E9CA2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74026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2" name="Line 149">
                <a:extLst>
                  <a:ext uri="{FF2B5EF4-FFF2-40B4-BE49-F238E27FC236}">
                    <a16:creationId xmlns:a16="http://schemas.microsoft.com/office/drawing/2014/main" id="{DB765915-62B8-4FC8-8B28-BC0281A38C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07376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3" name="Line 150">
                <a:extLst>
                  <a:ext uri="{FF2B5EF4-FFF2-40B4-BE49-F238E27FC236}">
                    <a16:creationId xmlns:a16="http://schemas.microsoft.com/office/drawing/2014/main" id="{915B8660-C50A-4289-B45C-E46C96A00A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58251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4" name="Line 151">
                <a:extLst>
                  <a:ext uri="{FF2B5EF4-FFF2-40B4-BE49-F238E27FC236}">
                    <a16:creationId xmlns:a16="http://schemas.microsoft.com/office/drawing/2014/main" id="{6DDA779F-A994-4397-AF1B-1CAE699247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78888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5" name="Line 152">
                <a:extLst>
                  <a:ext uri="{FF2B5EF4-FFF2-40B4-BE49-F238E27FC236}">
                    <a16:creationId xmlns:a16="http://schemas.microsoft.com/office/drawing/2014/main" id="{CDB90549-35E0-4F7A-B54E-132B1B9D23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034463" y="2606675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6" name="Line 153">
                <a:extLst>
                  <a:ext uri="{FF2B5EF4-FFF2-40B4-BE49-F238E27FC236}">
                    <a16:creationId xmlns:a16="http://schemas.microsoft.com/office/drawing/2014/main" id="{78573A10-78D2-48A2-A1F8-5050A56FC1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56688" y="2581275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grpSp>
        <p:nvGrpSpPr>
          <p:cNvPr id="171" name="Group 170">
            <a:extLst>
              <a:ext uri="{FF2B5EF4-FFF2-40B4-BE49-F238E27FC236}">
                <a16:creationId xmlns:a16="http://schemas.microsoft.com/office/drawing/2014/main" id="{7D3121C3-84E4-421B-9FE2-A9611CD36108}"/>
              </a:ext>
            </a:extLst>
          </p:cNvPr>
          <p:cNvGrpSpPr/>
          <p:nvPr/>
        </p:nvGrpSpPr>
        <p:grpSpPr>
          <a:xfrm>
            <a:off x="3799206" y="1524000"/>
            <a:ext cx="4067175" cy="2166938"/>
            <a:chOff x="3883026" y="1524000"/>
            <a:chExt cx="4067175" cy="2166938"/>
          </a:xfrm>
        </p:grpSpPr>
        <p:sp>
          <p:nvSpPr>
            <p:cNvPr id="157" name="Freeform 154">
              <a:extLst>
                <a:ext uri="{FF2B5EF4-FFF2-40B4-BE49-F238E27FC236}">
                  <a16:creationId xmlns:a16="http://schemas.microsoft.com/office/drawing/2014/main" id="{BE5EA894-A79C-4184-83AF-F8F1FAB6A46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83026" y="1524000"/>
              <a:ext cx="4044950" cy="2144713"/>
            </a:xfrm>
            <a:custGeom>
              <a:avLst/>
              <a:gdLst>
                <a:gd name="T0" fmla="*/ 0 w 2548"/>
                <a:gd name="T1" fmla="*/ 0 h 1351"/>
                <a:gd name="T2" fmla="*/ 74 w 2548"/>
                <a:gd name="T3" fmla="*/ 0 h 1351"/>
                <a:gd name="T4" fmla="*/ 74 w 2548"/>
                <a:gd name="T5" fmla="*/ 92 h 1351"/>
                <a:gd name="T6" fmla="*/ 120 w 2548"/>
                <a:gd name="T7" fmla="*/ 92 h 1351"/>
                <a:gd name="T8" fmla="*/ 120 w 2548"/>
                <a:gd name="T9" fmla="*/ 185 h 1351"/>
                <a:gd name="T10" fmla="*/ 124 w 2548"/>
                <a:gd name="T11" fmla="*/ 185 h 1351"/>
                <a:gd name="T12" fmla="*/ 274 w 2548"/>
                <a:gd name="T13" fmla="*/ 185 h 1351"/>
                <a:gd name="T14" fmla="*/ 274 w 2548"/>
                <a:gd name="T15" fmla="*/ 281 h 1351"/>
                <a:gd name="T16" fmla="*/ 392 w 2548"/>
                <a:gd name="T17" fmla="*/ 281 h 1351"/>
                <a:gd name="T18" fmla="*/ 881 w 2548"/>
                <a:gd name="T19" fmla="*/ 281 h 1351"/>
                <a:gd name="T20" fmla="*/ 881 w 2548"/>
                <a:gd name="T21" fmla="*/ 385 h 1351"/>
                <a:gd name="T22" fmla="*/ 909 w 2548"/>
                <a:gd name="T23" fmla="*/ 385 h 1351"/>
                <a:gd name="T24" fmla="*/ 909 w 2548"/>
                <a:gd name="T25" fmla="*/ 491 h 1351"/>
                <a:gd name="T26" fmla="*/ 993 w 2548"/>
                <a:gd name="T27" fmla="*/ 491 h 1351"/>
                <a:gd name="T28" fmla="*/ 993 w 2548"/>
                <a:gd name="T29" fmla="*/ 596 h 1351"/>
                <a:gd name="T30" fmla="*/ 1108 w 2548"/>
                <a:gd name="T31" fmla="*/ 596 h 1351"/>
                <a:gd name="T32" fmla="*/ 1108 w 2548"/>
                <a:gd name="T33" fmla="*/ 700 h 1351"/>
                <a:gd name="T34" fmla="*/ 1170 w 2548"/>
                <a:gd name="T35" fmla="*/ 700 h 1351"/>
                <a:gd name="T36" fmla="*/ 1170 w 2548"/>
                <a:gd name="T37" fmla="*/ 804 h 1351"/>
                <a:gd name="T38" fmla="*/ 1250 w 2548"/>
                <a:gd name="T39" fmla="*/ 804 h 1351"/>
                <a:gd name="T40" fmla="*/ 1250 w 2548"/>
                <a:gd name="T41" fmla="*/ 908 h 1351"/>
                <a:gd name="T42" fmla="*/ 1298 w 2548"/>
                <a:gd name="T43" fmla="*/ 908 h 1351"/>
                <a:gd name="T44" fmla="*/ 1298 w 2548"/>
                <a:gd name="T45" fmla="*/ 1017 h 1351"/>
                <a:gd name="T46" fmla="*/ 1650 w 2548"/>
                <a:gd name="T47" fmla="*/ 1017 h 1351"/>
                <a:gd name="T48" fmla="*/ 1674 w 2548"/>
                <a:gd name="T49" fmla="*/ 1017 h 1351"/>
                <a:gd name="T50" fmla="*/ 1696 w 2548"/>
                <a:gd name="T51" fmla="*/ 1017 h 1351"/>
                <a:gd name="T52" fmla="*/ 2235 w 2548"/>
                <a:gd name="T53" fmla="*/ 1017 h 1351"/>
                <a:gd name="T54" fmla="*/ 2235 w 2548"/>
                <a:gd name="T55" fmla="*/ 1181 h 1351"/>
                <a:gd name="T56" fmla="*/ 2315 w 2548"/>
                <a:gd name="T57" fmla="*/ 1181 h 1351"/>
                <a:gd name="T58" fmla="*/ 2315 w 2548"/>
                <a:gd name="T59" fmla="*/ 1351 h 1351"/>
                <a:gd name="T60" fmla="*/ 2447 w 2548"/>
                <a:gd name="T61" fmla="*/ 1351 h 1351"/>
                <a:gd name="T62" fmla="*/ 2508 w 2548"/>
                <a:gd name="T63" fmla="*/ 1351 h 1351"/>
                <a:gd name="T64" fmla="*/ 2548 w 2548"/>
                <a:gd name="T65" fmla="*/ 1351 h 1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2548" h="1351">
                  <a:moveTo>
                    <a:pt x="0" y="0"/>
                  </a:moveTo>
                  <a:lnTo>
                    <a:pt x="74" y="0"/>
                  </a:lnTo>
                  <a:lnTo>
                    <a:pt x="74" y="92"/>
                  </a:lnTo>
                  <a:lnTo>
                    <a:pt x="120" y="92"/>
                  </a:lnTo>
                  <a:lnTo>
                    <a:pt x="120" y="185"/>
                  </a:lnTo>
                  <a:lnTo>
                    <a:pt x="124" y="185"/>
                  </a:lnTo>
                  <a:lnTo>
                    <a:pt x="274" y="185"/>
                  </a:lnTo>
                  <a:lnTo>
                    <a:pt x="274" y="281"/>
                  </a:lnTo>
                  <a:lnTo>
                    <a:pt x="392" y="281"/>
                  </a:lnTo>
                  <a:lnTo>
                    <a:pt x="881" y="281"/>
                  </a:lnTo>
                  <a:lnTo>
                    <a:pt x="881" y="385"/>
                  </a:lnTo>
                  <a:lnTo>
                    <a:pt x="909" y="385"/>
                  </a:lnTo>
                  <a:lnTo>
                    <a:pt x="909" y="491"/>
                  </a:lnTo>
                  <a:lnTo>
                    <a:pt x="993" y="491"/>
                  </a:lnTo>
                  <a:lnTo>
                    <a:pt x="993" y="596"/>
                  </a:lnTo>
                  <a:lnTo>
                    <a:pt x="1108" y="596"/>
                  </a:lnTo>
                  <a:lnTo>
                    <a:pt x="1108" y="700"/>
                  </a:lnTo>
                  <a:lnTo>
                    <a:pt x="1170" y="700"/>
                  </a:lnTo>
                  <a:lnTo>
                    <a:pt x="1170" y="804"/>
                  </a:lnTo>
                  <a:lnTo>
                    <a:pt x="1250" y="804"/>
                  </a:lnTo>
                  <a:lnTo>
                    <a:pt x="1250" y="908"/>
                  </a:lnTo>
                  <a:lnTo>
                    <a:pt x="1298" y="908"/>
                  </a:lnTo>
                  <a:lnTo>
                    <a:pt x="1298" y="1017"/>
                  </a:lnTo>
                  <a:lnTo>
                    <a:pt x="1650" y="1017"/>
                  </a:lnTo>
                  <a:lnTo>
                    <a:pt x="1674" y="1017"/>
                  </a:lnTo>
                  <a:lnTo>
                    <a:pt x="1696" y="1017"/>
                  </a:lnTo>
                  <a:lnTo>
                    <a:pt x="2235" y="1017"/>
                  </a:lnTo>
                  <a:lnTo>
                    <a:pt x="2235" y="1181"/>
                  </a:lnTo>
                  <a:lnTo>
                    <a:pt x="2315" y="1181"/>
                  </a:lnTo>
                  <a:lnTo>
                    <a:pt x="2315" y="1351"/>
                  </a:lnTo>
                  <a:lnTo>
                    <a:pt x="2447" y="1351"/>
                  </a:lnTo>
                  <a:lnTo>
                    <a:pt x="2508" y="1351"/>
                  </a:lnTo>
                  <a:lnTo>
                    <a:pt x="2548" y="1351"/>
                  </a:lnTo>
                </a:path>
              </a:pathLst>
            </a:custGeom>
            <a:noFill/>
            <a:ln w="19050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7E63608C-C9EC-4DCF-A9B6-872455BB40C5}"/>
                </a:ext>
              </a:extLst>
            </p:cNvPr>
            <p:cNvGrpSpPr/>
            <p:nvPr/>
          </p:nvGrpSpPr>
          <p:grpSpPr>
            <a:xfrm>
              <a:off x="4057651" y="1793875"/>
              <a:ext cx="3892550" cy="1897063"/>
              <a:chOff x="4057651" y="1793875"/>
              <a:chExt cx="3892550" cy="1897063"/>
            </a:xfrm>
          </p:grpSpPr>
          <p:sp>
            <p:nvSpPr>
              <p:cNvPr id="158" name="Line 155">
                <a:extLst>
                  <a:ext uri="{FF2B5EF4-FFF2-40B4-BE49-F238E27FC236}">
                    <a16:creationId xmlns:a16="http://schemas.microsoft.com/office/drawing/2014/main" id="{DBA05E95-6F95-4B2F-980F-8F48B4C396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57651" y="1817688"/>
                <a:ext cx="44450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9" name="Line 156">
                <a:extLst>
                  <a:ext uri="{FF2B5EF4-FFF2-40B4-BE49-F238E27FC236}">
                    <a16:creationId xmlns:a16="http://schemas.microsoft.com/office/drawing/2014/main" id="{F6040C6A-2589-48EF-9370-CABBC48B18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9876" y="1793875"/>
                <a:ext cx="0" cy="460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0" name="Line 157">
                <a:extLst>
                  <a:ext uri="{FF2B5EF4-FFF2-40B4-BE49-F238E27FC236}">
                    <a16:creationId xmlns:a16="http://schemas.microsoft.com/office/drawing/2014/main" id="{7879564A-19FF-459A-B634-B1FBDABABF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05326" y="1947863"/>
                <a:ext cx="0" cy="4445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1" name="Line 158">
                <a:extLst>
                  <a:ext uri="{FF2B5EF4-FFF2-40B4-BE49-F238E27FC236}">
                    <a16:creationId xmlns:a16="http://schemas.microsoft.com/office/drawing/2014/main" id="{CB74BABB-CCEB-477D-B1D9-88521F3C67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02401" y="31130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2" name="Line 159">
                <a:extLst>
                  <a:ext uri="{FF2B5EF4-FFF2-40B4-BE49-F238E27FC236}">
                    <a16:creationId xmlns:a16="http://schemas.microsoft.com/office/drawing/2014/main" id="{71D2C559-2213-4EC3-BB03-88993F9040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40501" y="31130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3" name="Line 160">
                <a:extLst>
                  <a:ext uri="{FF2B5EF4-FFF2-40B4-BE49-F238E27FC236}">
                    <a16:creationId xmlns:a16="http://schemas.microsoft.com/office/drawing/2014/main" id="{14AED264-055B-40E9-8DDB-8B9C79C9F9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75426" y="3113088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4" name="Line 161">
                <a:extLst>
                  <a:ext uri="{FF2B5EF4-FFF2-40B4-BE49-F238E27FC236}">
                    <a16:creationId xmlns:a16="http://schemas.microsoft.com/office/drawing/2014/main" id="{0D0D29EE-E4BA-4BFD-A453-7EEDB29EE1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67638" y="364331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5" name="Line 162">
                <a:extLst>
                  <a:ext uri="{FF2B5EF4-FFF2-40B4-BE49-F238E27FC236}">
                    <a16:creationId xmlns:a16="http://schemas.microsoft.com/office/drawing/2014/main" id="{BE6E31FB-B598-4DDB-91C5-9017A245D0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64476" y="364331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6" name="Line 163">
                <a:extLst>
                  <a:ext uri="{FF2B5EF4-FFF2-40B4-BE49-F238E27FC236}">
                    <a16:creationId xmlns:a16="http://schemas.microsoft.com/office/drawing/2014/main" id="{928D3EB8-2E1C-4D3A-A4E0-8F08906F38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7902576" y="3668713"/>
                <a:ext cx="47625" cy="0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7" name="Line 164">
                <a:extLst>
                  <a:ext uri="{FF2B5EF4-FFF2-40B4-BE49-F238E27FC236}">
                    <a16:creationId xmlns:a16="http://schemas.microsoft.com/office/drawing/2014/main" id="{8814EFC1-DF47-4D90-9394-04BFE1DE41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27976" y="3643313"/>
                <a:ext cx="0" cy="47625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</p:grpSp>
      <p:sp>
        <p:nvSpPr>
          <p:cNvPr id="179" name="Rectangle 12">
            <a:extLst>
              <a:ext uri="{FF2B5EF4-FFF2-40B4-BE49-F238E27FC236}">
                <a16:creationId xmlns:a16="http://schemas.microsoft.com/office/drawing/2014/main" id="{B6D94A87-FC44-495D-AF20-58D2B60C0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5167" y="4976292"/>
            <a:ext cx="113238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b="1" dirty="0"/>
              <a:t>Number at risk:</a:t>
            </a:r>
          </a:p>
        </p:txBody>
      </p:sp>
      <p:sp>
        <p:nvSpPr>
          <p:cNvPr id="180" name="Rectangle 80">
            <a:extLst>
              <a:ext uri="{FF2B5EF4-FFF2-40B4-BE49-F238E27FC236}">
                <a16:creationId xmlns:a16="http://schemas.microsoft.com/office/drawing/2014/main" id="{B2C42214-1AE6-42F3-AB1C-131EB5D12A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1988" y="1606550"/>
            <a:ext cx="13914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1200" b="1" dirty="0"/>
              <a:t>Standard-Risk CAs</a:t>
            </a:r>
            <a:endParaRPr lang="en-US" altLang="en-US" sz="1200" dirty="0"/>
          </a:p>
        </p:txBody>
      </p:sp>
      <p:sp>
        <p:nvSpPr>
          <p:cNvPr id="181" name="Rectangle 81">
            <a:extLst>
              <a:ext uri="{FF2B5EF4-FFF2-40B4-BE49-F238E27FC236}">
                <a16:creationId xmlns:a16="http://schemas.microsoft.com/office/drawing/2014/main" id="{22B5494F-B2B6-4139-8986-C18A22002D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81988" y="1808163"/>
            <a:ext cx="1016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en-US" sz="1200" b="1" dirty="0"/>
              <a:t>High-risk CAs</a:t>
            </a:r>
            <a:endParaRPr lang="en-US" altLang="en-US" sz="1200" dirty="0"/>
          </a:p>
        </p:txBody>
      </p:sp>
      <p:sp>
        <p:nvSpPr>
          <p:cNvPr id="182" name="Line 84">
            <a:extLst>
              <a:ext uri="{FF2B5EF4-FFF2-40B4-BE49-F238E27FC236}">
                <a16:creationId xmlns:a16="http://schemas.microsoft.com/office/drawing/2014/main" id="{CD357F5F-7ADE-4992-980E-7D86837ED4DD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3213" y="1689100"/>
            <a:ext cx="304800" cy="0"/>
          </a:xfrm>
          <a:prstGeom prst="line">
            <a:avLst/>
          </a:prstGeom>
          <a:noFill/>
          <a:ln w="190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3" name="Line 85">
            <a:extLst>
              <a:ext uri="{FF2B5EF4-FFF2-40B4-BE49-F238E27FC236}">
                <a16:creationId xmlns:a16="http://schemas.microsoft.com/office/drawing/2014/main" id="{35EA1584-1B54-4764-941F-82022C988610}"/>
              </a:ext>
            </a:extLst>
          </p:cNvPr>
          <p:cNvSpPr>
            <a:spLocks noChangeShapeType="1"/>
          </p:cNvSpPr>
          <p:nvPr/>
        </p:nvSpPr>
        <p:spPr bwMode="auto">
          <a:xfrm>
            <a:off x="7929563" y="1893888"/>
            <a:ext cx="304800" cy="0"/>
          </a:xfrm>
          <a:prstGeom prst="line">
            <a:avLst/>
          </a:prstGeom>
          <a:noFill/>
          <a:ln w="19050" cap="flat">
            <a:solidFill>
              <a:srgbClr val="0000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3" name="Rectangle 33">
            <a:extLst>
              <a:ext uri="{FF2B5EF4-FFF2-40B4-BE49-F238E27FC236}">
                <a16:creationId xmlns:a16="http://schemas.microsoft.com/office/drawing/2014/main" id="{29A08CBC-CBB3-4AA4-96BD-5C4A8FBFA4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3019" y="4875571"/>
            <a:ext cx="236007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Time Since Enrollment (months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214" name="Rectangle 34">
            <a:extLst>
              <a:ext uri="{FF2B5EF4-FFF2-40B4-BE49-F238E27FC236}">
                <a16:creationId xmlns:a16="http://schemas.microsoft.com/office/drawing/2014/main" id="{9D1651B8-0CFA-4A80-A8D4-CD7B629A07B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080913" y="2874706"/>
            <a:ext cx="21961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Progression-Free Survival (%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293DD076-1DC6-457C-8DFA-F5FB98747D76}"/>
              </a:ext>
            </a:extLst>
          </p:cNvPr>
          <p:cNvGrpSpPr/>
          <p:nvPr/>
        </p:nvGrpSpPr>
        <p:grpSpPr>
          <a:xfrm>
            <a:off x="3791804" y="4075707"/>
            <a:ext cx="360362" cy="71438"/>
            <a:chOff x="8666163" y="1733025"/>
            <a:chExt cx="360362" cy="71438"/>
          </a:xfrm>
        </p:grpSpPr>
        <p:grpSp>
          <p:nvGrpSpPr>
            <p:cNvPr id="175" name="Group 174">
              <a:extLst>
                <a:ext uri="{FF2B5EF4-FFF2-40B4-BE49-F238E27FC236}">
                  <a16:creationId xmlns:a16="http://schemas.microsoft.com/office/drawing/2014/main" id="{E311297B-9A14-4907-A0B1-FEF460B7E193}"/>
                </a:ext>
              </a:extLst>
            </p:cNvPr>
            <p:cNvGrpSpPr/>
            <p:nvPr/>
          </p:nvGrpSpPr>
          <p:grpSpPr>
            <a:xfrm>
              <a:off x="8731251" y="1733025"/>
              <a:ext cx="228600" cy="71438"/>
              <a:chOff x="9364663" y="1801813"/>
              <a:chExt cx="228600" cy="71438"/>
            </a:xfrm>
          </p:grpSpPr>
          <p:sp>
            <p:nvSpPr>
              <p:cNvPr id="177" name="Line 51">
                <a:extLst>
                  <a:ext uri="{FF2B5EF4-FFF2-40B4-BE49-F238E27FC236}">
                    <a16:creationId xmlns:a16="http://schemas.microsoft.com/office/drawing/2014/main" id="{E82737DB-F609-483E-84D2-003E93F40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46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8" name="Line 52">
                <a:extLst>
                  <a:ext uri="{FF2B5EF4-FFF2-40B4-BE49-F238E27FC236}">
                    <a16:creationId xmlns:a16="http://schemas.microsoft.com/office/drawing/2014/main" id="{75C1D39E-AC4A-46A7-9287-06353B2FBE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80550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4" name="Line 53">
                <a:extLst>
                  <a:ext uri="{FF2B5EF4-FFF2-40B4-BE49-F238E27FC236}">
                    <a16:creationId xmlns:a16="http://schemas.microsoft.com/office/drawing/2014/main" id="{B1164DC2-7662-45A0-9975-9C1DC38332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932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76" name="Line 54">
              <a:extLst>
                <a:ext uri="{FF2B5EF4-FFF2-40B4-BE49-F238E27FC236}">
                  <a16:creationId xmlns:a16="http://schemas.microsoft.com/office/drawing/2014/main" id="{D32D6794-DD5A-4583-8579-26B0ABB4A6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6163" y="1771125"/>
              <a:ext cx="360362" cy="0"/>
            </a:xfrm>
            <a:prstGeom prst="line">
              <a:avLst/>
            </a:pr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4610CD86-6998-45F1-AC44-6391CF707E16}"/>
              </a:ext>
            </a:extLst>
          </p:cNvPr>
          <p:cNvGrpSpPr/>
          <p:nvPr/>
        </p:nvGrpSpPr>
        <p:grpSpPr>
          <a:xfrm>
            <a:off x="3791804" y="4353574"/>
            <a:ext cx="360362" cy="71438"/>
            <a:chOff x="8666163" y="1733025"/>
            <a:chExt cx="360362" cy="71438"/>
          </a:xfrm>
        </p:grpSpPr>
        <p:grpSp>
          <p:nvGrpSpPr>
            <p:cNvPr id="186" name="Group 185">
              <a:extLst>
                <a:ext uri="{FF2B5EF4-FFF2-40B4-BE49-F238E27FC236}">
                  <a16:creationId xmlns:a16="http://schemas.microsoft.com/office/drawing/2014/main" id="{AF9D8297-A0B4-4089-B7BE-A7926350EC5A}"/>
                </a:ext>
              </a:extLst>
            </p:cNvPr>
            <p:cNvGrpSpPr/>
            <p:nvPr/>
          </p:nvGrpSpPr>
          <p:grpSpPr>
            <a:xfrm>
              <a:off x="8731251" y="1733025"/>
              <a:ext cx="228600" cy="71438"/>
              <a:chOff x="9364663" y="1801813"/>
              <a:chExt cx="228600" cy="71438"/>
            </a:xfrm>
          </p:grpSpPr>
          <p:sp>
            <p:nvSpPr>
              <p:cNvPr id="188" name="Line 51">
                <a:extLst>
                  <a:ext uri="{FF2B5EF4-FFF2-40B4-BE49-F238E27FC236}">
                    <a16:creationId xmlns:a16="http://schemas.microsoft.com/office/drawing/2014/main" id="{5AE66AC0-4DAF-4F93-902B-7C1702AC98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646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9" name="Line 52">
                <a:extLst>
                  <a:ext uri="{FF2B5EF4-FFF2-40B4-BE49-F238E27FC236}">
                    <a16:creationId xmlns:a16="http://schemas.microsoft.com/office/drawing/2014/main" id="{390DCE9D-28AC-4897-AD7D-A68688D3A5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80550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0" name="Line 53">
                <a:extLst>
                  <a:ext uri="{FF2B5EF4-FFF2-40B4-BE49-F238E27FC236}">
                    <a16:creationId xmlns:a16="http://schemas.microsoft.com/office/drawing/2014/main" id="{5ABF28DF-C4F0-4193-93AE-BF7BE4C33F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93263" y="1801813"/>
                <a:ext cx="0" cy="71438"/>
              </a:xfrm>
              <a:prstGeom prst="line">
                <a:avLst/>
              </a:prstGeom>
              <a:noFill/>
              <a:ln w="12700" cap="flat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87" name="Line 54">
              <a:extLst>
                <a:ext uri="{FF2B5EF4-FFF2-40B4-BE49-F238E27FC236}">
                  <a16:creationId xmlns:a16="http://schemas.microsoft.com/office/drawing/2014/main" id="{50218676-4AC7-47A5-9A13-1BE700E7E6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66163" y="1771125"/>
              <a:ext cx="360362" cy="0"/>
            </a:xfrm>
            <a:prstGeom prst="line">
              <a:avLst/>
            </a:prstGeom>
            <a:noFill/>
            <a:ln w="19050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aphicFrame>
        <p:nvGraphicFramePr>
          <p:cNvPr id="191" name="Table 190">
            <a:extLst>
              <a:ext uri="{FF2B5EF4-FFF2-40B4-BE49-F238E27FC236}">
                <a16:creationId xmlns:a16="http://schemas.microsoft.com/office/drawing/2014/main" id="{399B013E-B194-44DB-9947-F9AC38FB9C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3131034"/>
              </p:ext>
            </p:extLst>
          </p:nvPr>
        </p:nvGraphicFramePr>
        <p:xfrm>
          <a:off x="4137718" y="3666054"/>
          <a:ext cx="5143499" cy="853668"/>
        </p:xfrm>
        <a:graphic>
          <a:graphicData uri="http://schemas.openxmlformats.org/drawingml/2006/table">
            <a:tbl>
              <a:tblPr firstRow="1" bandRow="1"/>
              <a:tblGrid>
                <a:gridCol w="1691582">
                  <a:extLst>
                    <a:ext uri="{9D8B030D-6E8A-4147-A177-3AD203B41FA5}">
                      <a16:colId xmlns:a16="http://schemas.microsoft.com/office/drawing/2014/main" val="856427517"/>
                    </a:ext>
                  </a:extLst>
                </a:gridCol>
                <a:gridCol w="830638">
                  <a:extLst>
                    <a:ext uri="{9D8B030D-6E8A-4147-A177-3AD203B41FA5}">
                      <a16:colId xmlns:a16="http://schemas.microsoft.com/office/drawing/2014/main" val="4179246454"/>
                    </a:ext>
                  </a:extLst>
                </a:gridCol>
                <a:gridCol w="2621279">
                  <a:extLst>
                    <a:ext uri="{9D8B030D-6E8A-4147-A177-3AD203B41FA5}">
                      <a16:colId xmlns:a16="http://schemas.microsoft.com/office/drawing/2014/main" val="3961210330"/>
                    </a:ext>
                  </a:extLst>
                </a:gridCol>
              </a:tblGrid>
              <a:tr h="301388"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months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4528241"/>
                  </a:ext>
                </a:extLst>
              </a:tr>
              <a:tr h="2761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-Risk CAs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73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1pPr>
                      <a:lvl2pPr marL="29062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2pPr>
                      <a:lvl3pPr marL="581260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3pPr>
                      <a:lvl4pPr marL="871889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4pPr>
                      <a:lvl5pPr marL="116251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5pPr>
                      <a:lvl6pPr marL="145314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6pPr>
                      <a:lvl7pPr marL="1743778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7pPr>
                      <a:lvl8pPr marL="203440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8pPr>
                      <a:lvl9pPr marL="2325037" algn="l" defTabSz="581260" rtl="0" eaLnBrk="1" latinLnBrk="0" hangingPunct="1">
                        <a:defRPr sz="1163" kern="1200">
                          <a:solidFill>
                            <a:schemeClr val="tx1"/>
                          </a:solidFill>
                          <a:latin typeface="Arial" panose="020B0604020202020204"/>
                        </a:defRPr>
                      </a:lvl9pPr>
                    </a:lstStyle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030826"/>
                  </a:ext>
                </a:extLst>
              </a:tr>
              <a:tr h="2761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-Risk CAs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/20</a:t>
                      </a:r>
                    </a:p>
                  </a:txBody>
                  <a:tcPr marL="68700" marR="68700" marT="28388" marB="2838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8 (95% CI, 7.6-NE)</a:t>
                      </a:r>
                    </a:p>
                  </a:txBody>
                  <a:tcPr marL="68700" marR="68700" marT="28388" marB="28388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8041010"/>
                  </a:ext>
                </a:extLst>
              </a:tr>
            </a:tbl>
          </a:graphicData>
        </a:graphic>
      </p:graphicFrame>
      <p:sp>
        <p:nvSpPr>
          <p:cNvPr id="192" name="TextBox 191">
            <a:extLst>
              <a:ext uri="{FF2B5EF4-FFF2-40B4-BE49-F238E27FC236}">
                <a16:creationId xmlns:a16="http://schemas.microsoft.com/office/drawing/2014/main" id="{F6E778F4-346F-4C9B-AE00-6A354C52D649}"/>
              </a:ext>
            </a:extLst>
          </p:cNvPr>
          <p:cNvSpPr txBox="1"/>
          <p:nvPr/>
        </p:nvSpPr>
        <p:spPr>
          <a:xfrm>
            <a:off x="1545631" y="6164826"/>
            <a:ext cx="9114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A, cytogenetic abnormality; NE,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not estimable; PF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progression-free survival.</a:t>
            </a:r>
          </a:p>
        </p:txBody>
      </p:sp>
    </p:spTree>
    <p:extLst>
      <p:ext uri="{BB962C8B-B14F-4D97-AF65-F5344CB8AC3E}">
        <p14:creationId xmlns:p14="http://schemas.microsoft.com/office/powerpoint/2010/main" val="3316037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0</TotalTime>
  <Words>104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wn Vahabzadeh, PharmD (MTM)</dc:creator>
  <cp:lastModifiedBy>Shawn Vahabzadeh, PharmD (MTM)</cp:lastModifiedBy>
  <cp:revision>83</cp:revision>
  <dcterms:created xsi:type="dcterms:W3CDTF">2018-07-18T19:14:30Z</dcterms:created>
  <dcterms:modified xsi:type="dcterms:W3CDTF">2020-05-01T19:42:56Z</dcterms:modified>
</cp:coreProperties>
</file>